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63" r:id="rId2"/>
    <p:sldId id="289" r:id="rId3"/>
    <p:sldId id="290" r:id="rId4"/>
    <p:sldId id="265" r:id="rId5"/>
    <p:sldId id="293" r:id="rId6"/>
    <p:sldId id="264" r:id="rId7"/>
    <p:sldId id="288" r:id="rId8"/>
    <p:sldId id="259" r:id="rId9"/>
    <p:sldId id="279" r:id="rId10"/>
    <p:sldId id="292" r:id="rId11"/>
    <p:sldId id="294" r:id="rId12"/>
    <p:sldId id="284" r:id="rId13"/>
    <p:sldId id="287" r:id="rId1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991F9DB0-C7B0-4159-B9D8-7F583E0AC2E4}">
          <p14:sldIdLst>
            <p14:sldId id="263"/>
            <p14:sldId id="289"/>
            <p14:sldId id="290"/>
            <p14:sldId id="265"/>
            <p14:sldId id="293"/>
            <p14:sldId id="264"/>
            <p14:sldId id="288"/>
            <p14:sldId id="259"/>
            <p14:sldId id="279"/>
            <p14:sldId id="292"/>
            <p14:sldId id="294"/>
            <p14:sldId id="284"/>
            <p14:sldId id="28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ena Lopez Knowles" initials="ELK" lastIdx="7" clrIdx="0">
    <p:extLst>
      <p:ext uri="{19B8F6BF-5375-455C-9EA6-DF929625EA0E}">
        <p15:presenceInfo xmlns:p15="http://schemas.microsoft.com/office/powerpoint/2012/main" userId="S-1-5-21-2720991719-3395378957-1752411362-797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CB"/>
    <a:srgbClr val="0000FF"/>
    <a:srgbClr val="FF0000"/>
    <a:srgbClr val="FFA5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Estilo medio 2 - Énfasis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Estilo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FECB4D8-DB02-4DC6-A0A2-4F2EBAE1DC90}" styleName="Estilo medio 1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073A0DAA-6AF3-43AB-8588-CEC1D06C72B9}" styleName="Estilo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7853C-536D-4A76-A0AE-DD22124D55A5}" styleName="Estilo temático 1 - Énfasis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505E3EF-67EA-436B-97B2-0124C06EBD24}" styleName="Estilo medio 4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8799B23B-EC83-4686-B30A-512413B5E67A}" styleName="Estilo claro 3 - Acent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B9631B5-78F2-41C9-869B-9F39066F8104}" styleName="Estilo medio 3 - 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16DA210-FB5B-4158-B5E0-FEB733F419BA}" styleName="Estilo cl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Estilo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ABFCF23-3B69-468F-B69F-88F6DE6A72F2}" styleName="Estilo medio 1 - Énfasis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0A1B5D5-9B99-4C35-A422-299274C87663}" styleName="Estilo medio 1 - Énfasis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138" autoAdjust="0"/>
    <p:restoredTop sz="95833" autoAdjust="0"/>
  </p:normalViewPr>
  <p:slideViewPr>
    <p:cSldViewPr snapToGrid="0">
      <p:cViewPr>
        <p:scale>
          <a:sx n="120" d="100"/>
          <a:sy n="120" d="100"/>
        </p:scale>
        <p:origin x="304" y="1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5" d="100"/>
        <a:sy n="6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AA3E57-A746-4D86-A2F2-0B299F75CC72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A3C7AD-35AD-423D-A109-61B42F86EE63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58112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1· TAKE HOME MESSAGE: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mographic characteristics are well balanced· </a:t>
            </a: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974805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AKE HOME MESSAGE: All the immune-related signatures are highly correlated· However the apoptosis and the claudin-low are not·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717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1· TAKE HOME MESSAGE: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mographic characteristics are well balanced· </a:t>
            </a: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513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AKE HOME message: Overall, here there is the association tests for the 40 genes  for both endpoints: 1·Ki67 response categories and residual Ki67 at two weeks timepoint·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121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·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KE HOME MESSAGE: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 expected, endocrine related signatures mainly ESR1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·Signalin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OXA1 and PGR associate with good response and low Ki67 at 2 weeks timepoint while ERBB2 associates with PR and high Ki67 at two weeks timepoint· Noteworthy, DNA-damage repair signatures such as the HRD, hypoxia, p53 and some involved in immune-checkpoint component such as IDO1 are associated with PR and high Ki67 at two weeks· High expression of apoptosis signature associates with GR and low Ki67 at two weeks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·</a:t>
            </a:r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·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KE HOME MESSAG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No significant differential signature expression between responders and non-responders were observed within HER2E subtypes for any of the Ki67 endpoints· However in luminal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nly, Proliferation and p53 were associated with high Ki67</a:t>
            </a:r>
            <a:r>
              <a:rPr lang="en-US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wk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ile high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 of AR signature was associated with low Ki67</a:t>
            </a:r>
            <a:r>
              <a:rPr lang="en-GB" sz="1200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wks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·</a:t>
            </a:r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8357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KE HOME MESSAGE: To further investigate the biological differences between these two groups we evaluated the ESR1 gene expression levels amongst the four intrinsic subtypes, distribut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ile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ERBB2 gene expression· The highest levels of ESR1 were seen in Luminal B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llowed by Luminal A, HER2-E and Basal like· Within the Luminal A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group of patients showed lower levels of ESR1 that seemed to be driven by higher ERBB2 signaling, especially when compared with other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ch as Luminal B or HER2-enriched </a:t>
            </a: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58398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GB" b="1" dirty="0"/>
              <a:t>Figure 4· TAKE HOME MESSAGE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sensus clustering based on single gene expression at baseline using ALL patients (treated and controls) shows 5 clusters for single gene expression and 4 for signature expression·</a:t>
            </a:r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single gene expression at baseline, cluster 1, 2 and 3 are characterized by poor response to AI and enrichment with HER2E subtype at baseline· Cluster 1 is enriched with immune and chemokine related genes, cluster 2 with extracellular matrix organization related genes and cluster 3 is far more “unexpressive” but expressing a group of genes that include DNA-damage repair genes such as BRCA, CCNE1, TRIP13, CDCA5, RFC4, KIF14 and BLM·  Cluster 4 and 5 are characterized by good response to AI and an enrichment of Luminal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· Both overexpress ER signaling, while cluster 5 also overexpresses MAPK/PI3K and RAS signaling·</a:t>
            </a:r>
          </a:p>
          <a:p>
            <a:pPr lvl="0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4B and 4C</a:t>
            </a:r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xplots from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ruskal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Wallis test showing differential levels of ERBB2 gene expression amongst the 5 clusters· Cluster 2, which is characterized by EMT high, has the highest levels of ERBB2· This is observed in the entire cohort (B) but not by subtypes when considering HER2E an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uminal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parately·</a:t>
            </a:r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endParaRPr lang="es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57572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98842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KE HOME MESSAG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ultivariable models that include the clusters + PAM50 add significant value to the clinic-pathological model alone and to the clinic-pathological model + PAM50 only· </a:t>
            </a:r>
            <a:r>
              <a:rPr lang="es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odel with the signature-based clusters has a high </a:t>
            </a:r>
            <a:r>
              <a:rPr lang="es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i-square likelihood ratio + lower degrees of freedom + 2 categories (cluster 2 and 4) with significant worse TT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suggesting that </a:t>
            </a:r>
            <a:r>
              <a:rPr lang="es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ignature-based clusters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ght </a:t>
            </a:r>
            <a:r>
              <a:rPr lang="es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d more value to the model based on PAM50 + clinicopatological variables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·</a:t>
            </a: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08459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AKE HOME MESSAGE: Immune related and apoptosis signatures correlate with lower risk of relapse while claudin-low does with higher risk of relapse·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3C7AD-35AD-423D-A109-61B42F86EE63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930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1122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6128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420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033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0590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451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75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3678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94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6745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363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E049-77F2-42AD-99FD-C8D54F26BDBF}" type="datetimeFigureOut">
              <a:rPr lang="en-GB" smtClean="0"/>
              <a:t>21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B6D02-6B9E-4664-AD8F-8056DE999B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5368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EA0864B5-A251-3D43-8190-413289439B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128" y="164038"/>
            <a:ext cx="6407111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GB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sort diagram of the study</a:t>
            </a:r>
            <a:endParaRPr lang="en-US" altLang="es-GB" sz="10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GB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: ER+, estrogen receptor positive; BC, Breast Cancer; IIT, insufficient infiltrating </a:t>
            </a:r>
            <a:r>
              <a:rPr kumimoji="0" lang="en-US" altLang="es-GB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·</a:t>
            </a: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EC035E9A-FA9C-4642-A184-134B5AC236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152" y="4163262"/>
            <a:ext cx="18473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-237243" y="1044875"/>
            <a:ext cx="7197062" cy="4104830"/>
            <a:chOff x="1859014" y="182658"/>
            <a:chExt cx="9792327" cy="5816598"/>
          </a:xfrm>
        </p:grpSpPr>
        <p:sp>
          <p:nvSpPr>
            <p:cNvPr id="7" name="CuadroTexto 4">
              <a:extLst>
                <a:ext uri="{FF2B5EF4-FFF2-40B4-BE49-F238E27FC236}">
                  <a16:creationId xmlns:a16="http://schemas.microsoft.com/office/drawing/2014/main" id="{88404227-5F42-3743-96BB-5A675774463A}"/>
                </a:ext>
              </a:extLst>
            </p:cNvPr>
            <p:cNvSpPr txBox="1"/>
            <p:nvPr/>
          </p:nvSpPr>
          <p:spPr>
            <a:xfrm>
              <a:off x="4797477" y="182658"/>
              <a:ext cx="2494803" cy="56696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80 ER+ BC patients in POETIC</a:t>
              </a:r>
            </a:p>
          </p:txBody>
        </p:sp>
        <p:sp>
          <p:nvSpPr>
            <p:cNvPr id="8" name="CuadroTexto 5">
              <a:extLst>
                <a:ext uri="{FF2B5EF4-FFF2-40B4-BE49-F238E27FC236}">
                  <a16:creationId xmlns:a16="http://schemas.microsoft.com/office/drawing/2014/main" id="{C0C44210-ADA8-7946-B88E-DF64CBB27C0B}"/>
                </a:ext>
              </a:extLst>
            </p:cNvPr>
            <p:cNvSpPr txBox="1"/>
            <p:nvPr/>
          </p:nvSpPr>
          <p:spPr>
            <a:xfrm>
              <a:off x="4888334" y="843321"/>
              <a:ext cx="2289390" cy="785023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R2+ BC 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 468 patients </a:t>
              </a:r>
            </a:p>
            <a:p>
              <a:pPr algn="ctr"/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uadroTexto 6">
              <a:extLst>
                <a:ext uri="{FF2B5EF4-FFF2-40B4-BE49-F238E27FC236}">
                  <a16:creationId xmlns:a16="http://schemas.microsoft.com/office/drawing/2014/main" id="{3CE22EF9-1BA5-EC4D-858D-B4BD7FD460AA}"/>
                </a:ext>
              </a:extLst>
            </p:cNvPr>
            <p:cNvSpPr txBox="1"/>
            <p:nvPr/>
          </p:nvSpPr>
          <p:spPr>
            <a:xfrm>
              <a:off x="8245823" y="1649730"/>
              <a:ext cx="1345879" cy="56696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ED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 316 patients</a:t>
              </a:r>
            </a:p>
          </p:txBody>
        </p:sp>
        <p:sp>
          <p:nvSpPr>
            <p:cNvPr id="10" name="CuadroTexto 7">
              <a:extLst>
                <a:ext uri="{FF2B5EF4-FFF2-40B4-BE49-F238E27FC236}">
                  <a16:creationId xmlns:a16="http://schemas.microsoft.com/office/drawing/2014/main" id="{62FB9314-EABA-9345-9FE7-3C6BA86F1982}"/>
                </a:ext>
              </a:extLst>
            </p:cNvPr>
            <p:cNvSpPr txBox="1"/>
            <p:nvPr/>
          </p:nvSpPr>
          <p:spPr>
            <a:xfrm>
              <a:off x="2609657" y="1662071"/>
              <a:ext cx="1372383" cy="56696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 152 patients</a:t>
              </a:r>
            </a:p>
          </p:txBody>
        </p:sp>
        <p:sp>
          <p:nvSpPr>
            <p:cNvPr id="11" name="CuadroTexto 8">
              <a:extLst>
                <a:ext uri="{FF2B5EF4-FFF2-40B4-BE49-F238E27FC236}">
                  <a16:creationId xmlns:a16="http://schemas.microsoft.com/office/drawing/2014/main" id="{7534DED2-6833-B34D-9346-66A8D948C308}"/>
                </a:ext>
              </a:extLst>
            </p:cNvPr>
            <p:cNvSpPr txBox="1"/>
            <p:nvPr/>
          </p:nvSpPr>
          <p:spPr>
            <a:xfrm>
              <a:off x="3241264" y="2492830"/>
              <a:ext cx="2869579" cy="1221145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SIONS:</a:t>
              </a:r>
            </a:p>
            <a:p>
              <a:pPr marL="285750" indent="-285750">
                <a:buFontTx/>
                <a:buChar char="-"/>
              </a:pP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 no blocks, ER negative or IIT</a:t>
              </a:r>
            </a:p>
            <a:p>
              <a:pPr marL="285750" indent="-285750">
                <a:buFontTx/>
                <a:buChar char="-"/>
              </a:pP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 insufficient RNA </a:t>
              </a:r>
            </a:p>
            <a:p>
              <a:pPr marL="285750" indent="-285750">
                <a:buFontTx/>
                <a:buChar char="-"/>
              </a:pP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failed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nostring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QC</a:t>
              </a:r>
            </a:p>
          </p:txBody>
        </p:sp>
        <p:sp>
          <p:nvSpPr>
            <p:cNvPr id="12" name="CuadroTexto 9">
              <a:extLst>
                <a:ext uri="{FF2B5EF4-FFF2-40B4-BE49-F238E27FC236}">
                  <a16:creationId xmlns:a16="http://schemas.microsoft.com/office/drawing/2014/main" id="{0A8C7669-1E3C-F048-AD5C-D83EBF044EFE}"/>
                </a:ext>
              </a:extLst>
            </p:cNvPr>
            <p:cNvSpPr txBox="1"/>
            <p:nvPr/>
          </p:nvSpPr>
          <p:spPr>
            <a:xfrm>
              <a:off x="8920124" y="2492830"/>
              <a:ext cx="2731217" cy="122114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CLUSIONS:</a:t>
              </a:r>
            </a:p>
            <a:p>
              <a:pPr marL="171450" indent="-171450">
                <a:buFontTx/>
                <a:buChar char="-"/>
              </a:pPr>
              <a:r>
                <a:rPr lang="en-GB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56 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blocks, ER negative or IIT</a:t>
              </a:r>
            </a:p>
            <a:p>
              <a:pPr marL="171450" indent="-171450">
                <a:buFontTx/>
                <a:buChar char="-"/>
              </a:pP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 insufficient RNA </a:t>
              </a:r>
            </a:p>
            <a:p>
              <a:pPr marL="171450" indent="-171450">
                <a:buFontTx/>
                <a:buChar char="-"/>
              </a:pP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failed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nostring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QC </a:t>
              </a:r>
            </a:p>
          </p:txBody>
        </p:sp>
        <p:cxnSp>
          <p:nvCxnSpPr>
            <p:cNvPr id="13" name="Conector recto 10">
              <a:extLst>
                <a:ext uri="{FF2B5EF4-FFF2-40B4-BE49-F238E27FC236}">
                  <a16:creationId xmlns:a16="http://schemas.microsoft.com/office/drawing/2014/main" id="{9E140789-F5E2-494E-B068-13BEE433AE46}"/>
                </a:ext>
              </a:extLst>
            </p:cNvPr>
            <p:cNvCxnSpPr>
              <a:cxnSpLocks/>
              <a:stCxn id="8" idx="1"/>
              <a:endCxn id="10" idx="0"/>
            </p:cNvCxnSpPr>
            <p:nvPr/>
          </p:nvCxnSpPr>
          <p:spPr>
            <a:xfrm flipH="1">
              <a:off x="3295849" y="1235832"/>
              <a:ext cx="1592485" cy="42623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Conector recto 11">
              <a:extLst>
                <a:ext uri="{FF2B5EF4-FFF2-40B4-BE49-F238E27FC236}">
                  <a16:creationId xmlns:a16="http://schemas.microsoft.com/office/drawing/2014/main" id="{4580FBDB-751B-394A-B50F-FEDF6083E987}"/>
                </a:ext>
              </a:extLst>
            </p:cNvPr>
            <p:cNvCxnSpPr>
              <a:cxnSpLocks/>
              <a:stCxn id="8" idx="3"/>
              <a:endCxn id="9" idx="0"/>
            </p:cNvCxnSpPr>
            <p:nvPr/>
          </p:nvCxnSpPr>
          <p:spPr>
            <a:xfrm>
              <a:off x="7177724" y="1235832"/>
              <a:ext cx="1741038" cy="4138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13">
              <a:extLst>
                <a:ext uri="{FF2B5EF4-FFF2-40B4-BE49-F238E27FC236}">
                  <a16:creationId xmlns:a16="http://schemas.microsoft.com/office/drawing/2014/main" id="{B7EA467A-520B-C248-BD5C-8F9F830842E9}"/>
                </a:ext>
              </a:extLst>
            </p:cNvPr>
            <p:cNvCxnSpPr>
              <a:cxnSpLocks/>
            </p:cNvCxnSpPr>
            <p:nvPr/>
          </p:nvCxnSpPr>
          <p:spPr>
            <a:xfrm>
              <a:off x="8880526" y="2345053"/>
              <a:ext cx="1" cy="133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Conector recto 14">
              <a:extLst>
                <a:ext uri="{FF2B5EF4-FFF2-40B4-BE49-F238E27FC236}">
                  <a16:creationId xmlns:a16="http://schemas.microsoft.com/office/drawing/2014/main" id="{D549B16D-7670-B445-88CD-19B5927D3D39}"/>
                </a:ext>
              </a:extLst>
            </p:cNvPr>
            <p:cNvCxnSpPr>
              <a:cxnSpLocks/>
            </p:cNvCxnSpPr>
            <p:nvPr/>
          </p:nvCxnSpPr>
          <p:spPr>
            <a:xfrm>
              <a:off x="3170993" y="2447164"/>
              <a:ext cx="6747" cy="1336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9D74E897-3665-FE48-A126-3E81731B915D}"/>
                </a:ext>
              </a:extLst>
            </p:cNvPr>
            <p:cNvSpPr txBox="1"/>
            <p:nvPr/>
          </p:nvSpPr>
          <p:spPr>
            <a:xfrm>
              <a:off x="3170994" y="5432295"/>
              <a:ext cx="5747770" cy="5669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number of patients n= 342</a:t>
              </a:r>
            </a:p>
            <a:p>
              <a:pPr algn="ctr"/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number of patients with Ki67 n= 277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DFC693B2-97AB-CF41-BF48-CA7CC2C04622}"/>
                </a:ext>
              </a:extLst>
            </p:cNvPr>
            <p:cNvSpPr txBox="1"/>
            <p:nvPr/>
          </p:nvSpPr>
          <p:spPr>
            <a:xfrm>
              <a:off x="1859014" y="3900081"/>
              <a:ext cx="2873672" cy="78502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S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 105 patients</a:t>
              </a:r>
            </a:p>
            <a:p>
              <a:pPr algn="ctr"/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25FD8CAD-A133-484A-9093-53DFF3D4DCA4}"/>
                </a:ext>
              </a:extLst>
            </p:cNvPr>
            <p:cNvSpPr txBox="1"/>
            <p:nvPr/>
          </p:nvSpPr>
          <p:spPr>
            <a:xfrm>
              <a:off x="7218442" y="3827141"/>
              <a:ext cx="3400642" cy="78502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ED</a:t>
              </a:r>
            </a:p>
            <a:p>
              <a:pPr algn="ctr"/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 237 patients </a:t>
              </a:r>
            </a:p>
            <a:p>
              <a:pPr algn="ctr"/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Conector recto 21">
              <a:extLst>
                <a:ext uri="{FF2B5EF4-FFF2-40B4-BE49-F238E27FC236}">
                  <a16:creationId xmlns:a16="http://schemas.microsoft.com/office/drawing/2014/main" id="{A2F46758-332F-BA40-BFFE-4F610630C999}"/>
                </a:ext>
              </a:extLst>
            </p:cNvPr>
            <p:cNvCxnSpPr>
              <a:cxnSpLocks/>
            </p:cNvCxnSpPr>
            <p:nvPr/>
          </p:nvCxnSpPr>
          <p:spPr>
            <a:xfrm>
              <a:off x="3170993" y="4630943"/>
              <a:ext cx="0" cy="648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Conector recto 22">
              <a:extLst>
                <a:ext uri="{FF2B5EF4-FFF2-40B4-BE49-F238E27FC236}">
                  <a16:creationId xmlns:a16="http://schemas.microsoft.com/office/drawing/2014/main" id="{E3FDD919-5127-AA44-BC57-0D2098B96114}"/>
                </a:ext>
              </a:extLst>
            </p:cNvPr>
            <p:cNvCxnSpPr>
              <a:cxnSpLocks/>
            </p:cNvCxnSpPr>
            <p:nvPr/>
          </p:nvCxnSpPr>
          <p:spPr>
            <a:xfrm>
              <a:off x="8906913" y="4481325"/>
              <a:ext cx="0" cy="73247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Conector recto 32">
              <a:extLst>
                <a:ext uri="{FF2B5EF4-FFF2-40B4-BE49-F238E27FC236}">
                  <a16:creationId xmlns:a16="http://schemas.microsoft.com/office/drawing/2014/main" id="{8AA9A8A8-4B11-6347-A632-F7276F36F329}"/>
                </a:ext>
              </a:extLst>
            </p:cNvPr>
            <p:cNvCxnSpPr>
              <a:cxnSpLocks/>
            </p:cNvCxnSpPr>
            <p:nvPr/>
          </p:nvCxnSpPr>
          <p:spPr>
            <a:xfrm>
              <a:off x="5960024" y="490435"/>
              <a:ext cx="0" cy="33459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3334127" y="4738393"/>
              <a:ext cx="2137863" cy="348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 patients with  Ki67 data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9081897" y="4738393"/>
              <a:ext cx="2181484" cy="3488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7 </a:t>
              </a:r>
              <a:r>
                <a:rPr lang="en-GB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Ki67 data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646759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E5F577ED-0AD2-CD4F-A735-DDCE830D38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03" r="6110"/>
          <a:stretch/>
        </p:blipFill>
        <p:spPr>
          <a:xfrm>
            <a:off x="269873" y="1717565"/>
            <a:ext cx="6448790" cy="4179421"/>
          </a:xfrm>
          <a:prstGeom prst="rect">
            <a:avLst/>
          </a:prstGeom>
        </p:spPr>
      </p:pic>
      <p:sp>
        <p:nvSpPr>
          <p:cNvPr id="7" name="Cerrar llave 6">
            <a:extLst>
              <a:ext uri="{FF2B5EF4-FFF2-40B4-BE49-F238E27FC236}">
                <a16:creationId xmlns:a16="http://schemas.microsoft.com/office/drawing/2014/main" id="{70200193-8EB1-554D-B0DA-5B30AB9EFBC0}"/>
              </a:ext>
            </a:extLst>
          </p:cNvPr>
          <p:cNvSpPr/>
          <p:nvPr/>
        </p:nvSpPr>
        <p:spPr>
          <a:xfrm rot="16200000">
            <a:off x="2385296" y="1195133"/>
            <a:ext cx="114676" cy="1413933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3DD84BB7-6193-7041-88F1-439D1ED58287}"/>
              </a:ext>
            </a:extLst>
          </p:cNvPr>
          <p:cNvSpPr txBox="1"/>
          <p:nvPr/>
        </p:nvSpPr>
        <p:spPr>
          <a:xfrm>
            <a:off x="2063303" y="1617987"/>
            <a:ext cx="1251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=0·053</a:t>
            </a:r>
          </a:p>
        </p:txBody>
      </p:sp>
      <p:sp>
        <p:nvSpPr>
          <p:cNvPr id="14" name="Cerrar llave 13">
            <a:extLst>
              <a:ext uri="{FF2B5EF4-FFF2-40B4-BE49-F238E27FC236}">
                <a16:creationId xmlns:a16="http://schemas.microsoft.com/office/drawing/2014/main" id="{7A412D1B-EE87-D748-8BAF-4E17F5226250}"/>
              </a:ext>
            </a:extLst>
          </p:cNvPr>
          <p:cNvSpPr/>
          <p:nvPr/>
        </p:nvSpPr>
        <p:spPr>
          <a:xfrm rot="16200000">
            <a:off x="4216508" y="-250587"/>
            <a:ext cx="165370" cy="2527299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D43917EE-0234-6C4E-8F80-4FCAC20B7247}"/>
              </a:ext>
            </a:extLst>
          </p:cNvPr>
          <p:cNvSpPr txBox="1"/>
          <p:nvPr/>
        </p:nvSpPr>
        <p:spPr>
          <a:xfrm>
            <a:off x="3966616" y="684156"/>
            <a:ext cx="1251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=0·0025</a:t>
            </a: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7332CDD3-07A7-0040-8F4A-4AB5D6D6751A}"/>
              </a:ext>
            </a:extLst>
          </p:cNvPr>
          <p:cNvSpPr/>
          <p:nvPr/>
        </p:nvSpPr>
        <p:spPr>
          <a:xfrm>
            <a:off x="269873" y="200606"/>
            <a:ext cx="631825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s-GB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5. </a:t>
            </a:r>
            <a:r>
              <a:rPr lang="en-U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rplots</a:t>
            </a:r>
            <a:r>
              <a:rPr lang="en-U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mparing the multivariate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-square likelihood test for each multivariable model. </a:t>
            </a:r>
            <a:r>
              <a:rPr lang="en-GB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GB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: p-value; DF: degrees of freedom.</a:t>
            </a:r>
            <a:endParaRPr lang="en-US" altLang="es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errar llave 21">
            <a:extLst>
              <a:ext uri="{FF2B5EF4-FFF2-40B4-BE49-F238E27FC236}">
                <a16:creationId xmlns:a16="http://schemas.microsoft.com/office/drawing/2014/main" id="{4CB6DA2F-336A-DE4A-A9C3-CBFB73115798}"/>
              </a:ext>
            </a:extLst>
          </p:cNvPr>
          <p:cNvSpPr/>
          <p:nvPr/>
        </p:nvSpPr>
        <p:spPr>
          <a:xfrm rot="16200000">
            <a:off x="2884599" y="252790"/>
            <a:ext cx="301888" cy="2582333"/>
          </a:xfrm>
          <a:prstGeom prst="rightBrac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31BDCA4B-1E3C-544A-BB39-03F0654B90CC}"/>
              </a:ext>
            </a:extLst>
          </p:cNvPr>
          <p:cNvSpPr txBox="1"/>
          <p:nvPr/>
        </p:nvSpPr>
        <p:spPr>
          <a:xfrm>
            <a:off x="2688945" y="1179188"/>
            <a:ext cx="12512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=0·0012</a:t>
            </a:r>
          </a:p>
        </p:txBody>
      </p:sp>
    </p:spTree>
    <p:extLst>
      <p:ext uri="{BB962C8B-B14F-4D97-AF65-F5344CB8AC3E}">
        <p14:creationId xmlns:p14="http://schemas.microsoft.com/office/powerpoint/2010/main" val="31569479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95BD497B-9E01-E148-0E6C-33CF9560065D}"/>
              </a:ext>
            </a:extLst>
          </p:cNvPr>
          <p:cNvSpPr/>
          <p:nvPr/>
        </p:nvSpPr>
        <p:spPr>
          <a:xfrm>
            <a:off x="269873" y="200606"/>
            <a:ext cx="631825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s-GB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6.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plan Meier curves stratified by adjuvant treatment (trastuzumab + chemotherapy yes vs no) for TTR according to a. PAM50 Intrinsic Subtypes and b. to the new molecular subgroups. </a:t>
            </a:r>
            <a:r>
              <a:rPr lang="en-GB" sz="10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: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R2-E: HER2-enriched, </a:t>
            </a:r>
            <a:r>
              <a:rPr lang="en-GB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:Chemotherapy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TR: Time To Recurrence.</a:t>
            </a:r>
            <a:endParaRPr lang="en-US" altLang="es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33">
            <a:extLst>
              <a:ext uri="{FF2B5EF4-FFF2-40B4-BE49-F238E27FC236}">
                <a16:creationId xmlns:a16="http://schemas.microsoft.com/office/drawing/2014/main" id="{FE434FED-B30D-7511-9875-43083E0E455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159" t="11573" r="50123" b="24652"/>
          <a:stretch/>
        </p:blipFill>
        <p:spPr bwMode="auto">
          <a:xfrm>
            <a:off x="539746" y="1181626"/>
            <a:ext cx="2832104" cy="177372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5BFEF5DA-E917-9B7B-58D6-8EC72C63FDF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6347" b="25187"/>
          <a:stretch/>
        </p:blipFill>
        <p:spPr>
          <a:xfrm>
            <a:off x="432342" y="1005043"/>
            <a:ext cx="153757" cy="1890241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1504B4D3-E3BD-1DD9-36BA-C397FF01FD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086" r="100000"/>
          <a:stretch/>
        </p:blipFill>
        <p:spPr>
          <a:xfrm>
            <a:off x="540380" y="1513207"/>
            <a:ext cx="45719" cy="2526627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D32DCEA8-2608-0F08-5B3C-A41872A924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9198" r="92231" b="12392"/>
          <a:stretch/>
        </p:blipFill>
        <p:spPr>
          <a:xfrm>
            <a:off x="447638" y="3169897"/>
            <a:ext cx="326995" cy="212479"/>
          </a:xfrm>
          <a:prstGeom prst="rect">
            <a:avLst/>
          </a:prstGeom>
        </p:spPr>
      </p:pic>
      <p:pic>
        <p:nvPicPr>
          <p:cNvPr id="11" name="Picture 33">
            <a:extLst>
              <a:ext uri="{FF2B5EF4-FFF2-40B4-BE49-F238E27FC236}">
                <a16:creationId xmlns:a16="http://schemas.microsoft.com/office/drawing/2014/main" id="{E617A9E0-C104-39C5-1A1F-345F2DE29D0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0130" t="11573" b="24652"/>
          <a:stretch/>
        </p:blipFill>
        <p:spPr bwMode="auto">
          <a:xfrm>
            <a:off x="3857910" y="1152199"/>
            <a:ext cx="2773049" cy="177372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C032B148-457B-7B95-BDFE-E9FDC7362B0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6347" b="25187"/>
          <a:stretch/>
        </p:blipFill>
        <p:spPr>
          <a:xfrm>
            <a:off x="3704153" y="1005043"/>
            <a:ext cx="153757" cy="1890241"/>
          </a:xfrm>
          <a:prstGeom prst="rect">
            <a:avLst/>
          </a:prstGeom>
        </p:spPr>
      </p:pic>
      <p:pic>
        <p:nvPicPr>
          <p:cNvPr id="14" name="Picture 33">
            <a:extLst>
              <a:ext uri="{FF2B5EF4-FFF2-40B4-BE49-F238E27FC236}">
                <a16:creationId xmlns:a16="http://schemas.microsoft.com/office/drawing/2014/main" id="{4D1F821D-00A4-4850-4B1A-2A98B0F3FF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825" t="75768" r="50119"/>
          <a:stretch/>
        </p:blipFill>
        <p:spPr bwMode="auto">
          <a:xfrm>
            <a:off x="812512" y="2906907"/>
            <a:ext cx="2577332" cy="67397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EB7AF828-087D-8229-F273-35B4B14AD6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7239" r="92327" b="8013"/>
          <a:stretch/>
        </p:blipFill>
        <p:spPr>
          <a:xfrm>
            <a:off x="451659" y="3094029"/>
            <a:ext cx="322974" cy="119958"/>
          </a:xfrm>
          <a:prstGeom prst="rect">
            <a:avLst/>
          </a:prstGeom>
        </p:spPr>
      </p:pic>
      <p:pic>
        <p:nvPicPr>
          <p:cNvPr id="16" name="Picture 33">
            <a:extLst>
              <a:ext uri="{FF2B5EF4-FFF2-40B4-BE49-F238E27FC236}">
                <a16:creationId xmlns:a16="http://schemas.microsoft.com/office/drawing/2014/main" id="{7B70D953-1333-D8E6-22B5-AC8CCDD9A6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679" t="74721" b="6666"/>
          <a:stretch/>
        </p:blipFill>
        <p:spPr bwMode="auto">
          <a:xfrm>
            <a:off x="4047935" y="2889186"/>
            <a:ext cx="2577332" cy="51399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9" name="CuadroTexto 18">
            <a:extLst>
              <a:ext uri="{FF2B5EF4-FFF2-40B4-BE49-F238E27FC236}">
                <a16:creationId xmlns:a16="http://schemas.microsoft.com/office/drawing/2014/main" id="{1DB9E950-4771-BEAF-6E9F-472563611A4A}"/>
              </a:ext>
            </a:extLst>
          </p:cNvPr>
          <p:cNvSpPr txBox="1"/>
          <p:nvPr/>
        </p:nvSpPr>
        <p:spPr>
          <a:xfrm>
            <a:off x="269873" y="866543"/>
            <a:ext cx="726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D8E6889D-F8D8-301A-BE63-2F3F202DD834}"/>
              </a:ext>
            </a:extLst>
          </p:cNvPr>
          <p:cNvSpPr txBox="1"/>
          <p:nvPr/>
        </p:nvSpPr>
        <p:spPr>
          <a:xfrm>
            <a:off x="800827" y="852342"/>
            <a:ext cx="5725510" cy="2778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stuzumab + CT no: HER2-E vs </a:t>
            </a:r>
            <a:r>
              <a:rPr lang="en-US" sz="900" b="1" u="sng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minals</a:t>
            </a:r>
            <a:r>
              <a:rPr lang="en-US" sz="9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	                 </a:t>
            </a: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stuzumab + CT yes: HER2-E vs </a:t>
            </a:r>
            <a:r>
              <a:rPr lang="en-US" sz="900" b="1" u="sng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minals</a:t>
            </a:r>
            <a:endParaRPr lang="es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2" name="Picture 15">
            <a:extLst>
              <a:ext uri="{FF2B5EF4-FFF2-40B4-BE49-F238E27FC236}">
                <a16:creationId xmlns:a16="http://schemas.microsoft.com/office/drawing/2014/main" id="{A932FFBC-7046-7129-A756-D80BB51E35F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840" t="11837" r="50000" b="24097"/>
          <a:stretch/>
        </p:blipFill>
        <p:spPr>
          <a:xfrm>
            <a:off x="753931" y="4757913"/>
            <a:ext cx="2675069" cy="1706782"/>
          </a:xfrm>
          <a:prstGeom prst="rect">
            <a:avLst/>
          </a:prstGeom>
        </p:spPr>
      </p:pic>
      <p:pic>
        <p:nvPicPr>
          <p:cNvPr id="23" name="Picture 15">
            <a:extLst>
              <a:ext uri="{FF2B5EF4-FFF2-40B4-BE49-F238E27FC236}">
                <a16:creationId xmlns:a16="http://schemas.microsoft.com/office/drawing/2014/main" id="{0B7BAEF6-A5D2-D34A-2F6F-DDD22585B8B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806" t="-67297" r="-5652" b="103231"/>
          <a:stretch/>
        </p:blipFill>
        <p:spPr>
          <a:xfrm>
            <a:off x="708212" y="5599454"/>
            <a:ext cx="6051284" cy="1706782"/>
          </a:xfrm>
          <a:prstGeom prst="rect">
            <a:avLst/>
          </a:prstGeom>
        </p:spPr>
      </p:pic>
      <p:pic>
        <p:nvPicPr>
          <p:cNvPr id="25" name="Picture 15">
            <a:extLst>
              <a:ext uri="{FF2B5EF4-FFF2-40B4-BE49-F238E27FC236}">
                <a16:creationId xmlns:a16="http://schemas.microsoft.com/office/drawing/2014/main" id="{ADF65A08-E61F-F056-761B-D96163506CE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1909" t="75133"/>
          <a:stretch/>
        </p:blipFill>
        <p:spPr>
          <a:xfrm>
            <a:off x="4067989" y="6387815"/>
            <a:ext cx="2537223" cy="662469"/>
          </a:xfrm>
          <a:prstGeom prst="rect">
            <a:avLst/>
          </a:prstGeom>
        </p:spPr>
      </p:pic>
      <p:pic>
        <p:nvPicPr>
          <p:cNvPr id="26" name="Picture 15">
            <a:extLst>
              <a:ext uri="{FF2B5EF4-FFF2-40B4-BE49-F238E27FC236}">
                <a16:creationId xmlns:a16="http://schemas.microsoft.com/office/drawing/2014/main" id="{5C1E8520-F11A-B9F5-EDCC-5EA6DF0B45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8005" t="11837" b="24097"/>
          <a:stretch/>
        </p:blipFill>
        <p:spPr>
          <a:xfrm>
            <a:off x="3827992" y="4703599"/>
            <a:ext cx="2797275" cy="1706782"/>
          </a:xfrm>
          <a:prstGeom prst="rect">
            <a:avLst/>
          </a:prstGeom>
        </p:spPr>
      </p:pic>
      <p:pic>
        <p:nvPicPr>
          <p:cNvPr id="28" name="Picture 15">
            <a:extLst>
              <a:ext uri="{FF2B5EF4-FFF2-40B4-BE49-F238E27FC236}">
                <a16:creationId xmlns:a16="http://schemas.microsoft.com/office/drawing/2014/main" id="{F0056B4E-CE24-1F57-A56A-40A2158A35E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130" t="74243" r="50000" b="890"/>
          <a:stretch/>
        </p:blipFill>
        <p:spPr>
          <a:xfrm>
            <a:off x="906509" y="6399608"/>
            <a:ext cx="2522491" cy="662469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60E1495E-41C5-CE25-873B-F54923E47B4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9098" r="94269"/>
          <a:stretch/>
        </p:blipFill>
        <p:spPr>
          <a:xfrm>
            <a:off x="708212" y="6533968"/>
            <a:ext cx="244893" cy="528109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9E8B9C04-1905-21F9-6167-55F081790C0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9098" r="94269"/>
          <a:stretch/>
        </p:blipFill>
        <p:spPr>
          <a:xfrm>
            <a:off x="3872424" y="6505412"/>
            <a:ext cx="244893" cy="528109"/>
          </a:xfrm>
          <a:prstGeom prst="rect">
            <a:avLst/>
          </a:prstGeom>
        </p:spPr>
      </p:pic>
      <p:pic>
        <p:nvPicPr>
          <p:cNvPr id="31" name="Imagen 30">
            <a:extLst>
              <a:ext uri="{FF2B5EF4-FFF2-40B4-BE49-F238E27FC236}">
                <a16:creationId xmlns:a16="http://schemas.microsoft.com/office/drawing/2014/main" id="{C8F26375-4C1E-1C49-7F0E-906CA0214E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6347" b="25187"/>
          <a:stretch/>
        </p:blipFill>
        <p:spPr>
          <a:xfrm>
            <a:off x="3733854" y="4643727"/>
            <a:ext cx="153757" cy="1890241"/>
          </a:xfrm>
          <a:prstGeom prst="rect">
            <a:avLst/>
          </a:prstGeom>
        </p:spPr>
      </p:pic>
      <p:pic>
        <p:nvPicPr>
          <p:cNvPr id="32" name="Imagen 31">
            <a:extLst>
              <a:ext uri="{FF2B5EF4-FFF2-40B4-BE49-F238E27FC236}">
                <a16:creationId xmlns:a16="http://schemas.microsoft.com/office/drawing/2014/main" id="{860EB0EE-8326-B9BA-4721-828D28898D6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6347" b="25187"/>
          <a:stretch/>
        </p:blipFill>
        <p:spPr>
          <a:xfrm>
            <a:off x="445890" y="4643726"/>
            <a:ext cx="153757" cy="1890241"/>
          </a:xfrm>
          <a:prstGeom prst="rect">
            <a:avLst/>
          </a:prstGeom>
        </p:spPr>
      </p:pic>
      <p:sp>
        <p:nvSpPr>
          <p:cNvPr id="33" name="CuadroTexto 32">
            <a:extLst>
              <a:ext uri="{FF2B5EF4-FFF2-40B4-BE49-F238E27FC236}">
                <a16:creationId xmlns:a16="http://schemas.microsoft.com/office/drawing/2014/main" id="{2B11DEF5-BFCD-3C79-6710-F32CE43C30E5}"/>
              </a:ext>
            </a:extLst>
          </p:cNvPr>
          <p:cNvSpPr txBox="1"/>
          <p:nvPr/>
        </p:nvSpPr>
        <p:spPr>
          <a:xfrm>
            <a:off x="708212" y="4379981"/>
            <a:ext cx="5986591" cy="2778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stuzumab + CT no: </a:t>
            </a:r>
            <a:r>
              <a:rPr lang="en-US" sz="9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 molecular subgroups</a:t>
            </a:r>
            <a:r>
              <a:rPr lang="en-US" sz="9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	                 </a:t>
            </a: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stuzumab + CT yes: </a:t>
            </a:r>
            <a:r>
              <a:rPr lang="en-US" sz="9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sz="900" b="1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w molecular subgroups</a:t>
            </a:r>
            <a:endParaRPr lang="es-GB" sz="7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EBC00210-B64B-1FCD-18A9-35BFF424CEE6}"/>
              </a:ext>
            </a:extLst>
          </p:cNvPr>
          <p:cNvSpPr txBox="1"/>
          <p:nvPr/>
        </p:nvSpPr>
        <p:spPr>
          <a:xfrm>
            <a:off x="272887" y="4234435"/>
            <a:ext cx="726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D461A5C8-606F-6534-0E17-17098194E1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9198" r="92231" b="12392"/>
          <a:stretch/>
        </p:blipFill>
        <p:spPr>
          <a:xfrm>
            <a:off x="3737169" y="3169897"/>
            <a:ext cx="326995" cy="212479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E7510AEC-10E1-1352-D012-0A89397F024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7239" r="92327" b="8013"/>
          <a:stretch/>
        </p:blipFill>
        <p:spPr>
          <a:xfrm>
            <a:off x="3741190" y="3094029"/>
            <a:ext cx="322974" cy="119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12917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E6D53D5D-0CE7-CA4A-9360-0F8034A9F281}"/>
              </a:ext>
            </a:extLst>
          </p:cNvPr>
          <p:cNvSpPr/>
          <p:nvPr/>
        </p:nvSpPr>
        <p:spPr>
          <a:xfrm>
            <a:off x="136262" y="148132"/>
            <a:ext cx="6533029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7. 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es of multivariable analysis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TR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ignature expression adjusted by the basic clinicopathological factors (age, nodal status, post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ze, post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de). </a:t>
            </a:r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R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rogen Receptor 1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ene HER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A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khead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A1;  HRD, Homologous Recombination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gesterone Receptor, BC: Breast Cancer Signature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1; Treg, Regulatory T cells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osphatase and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nsi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log;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O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doleamine 2,3-dioxygenase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rogen Receptor, IFN Gamma, Interferon Gamma; TIS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lammation Signature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2; TIGIT, T cell immunoreceptor with Ig and ITIM  domain; APM, Antigen Processing Machinery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CAnes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Breast Cancer Gene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6, 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6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F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ransforming growth Factor Bet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blastom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RY(Sex determining region Y)-box2; MHC2, major histocompatibility complex 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cell death protein 1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4; CD8 T cells, Cytotoxic T lymphocytes; HR, Hazard Ratio; FDR, False discovery rate, CI: Confidence Interval.</a:t>
            </a:r>
          </a:p>
          <a:p>
            <a:pPr algn="just"/>
            <a:b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Marcador de contenido 3">
            <a:extLst>
              <a:ext uri="{FF2B5EF4-FFF2-40B4-BE49-F238E27FC236}">
                <a16:creationId xmlns:a16="http://schemas.microsoft.com/office/drawing/2014/main" id="{FAB11F05-32CC-A941-AE10-B5DF7A9F549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03932401"/>
              </p:ext>
            </p:extLst>
          </p:nvPr>
        </p:nvGraphicFramePr>
        <p:xfrm>
          <a:off x="256354" y="1846100"/>
          <a:ext cx="6369043" cy="777511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514663">
                  <a:extLst>
                    <a:ext uri="{9D8B030D-6E8A-4147-A177-3AD203B41FA5}">
                      <a16:colId xmlns:a16="http://schemas.microsoft.com/office/drawing/2014/main" val="440260367"/>
                    </a:ext>
                  </a:extLst>
                </a:gridCol>
                <a:gridCol w="881484">
                  <a:extLst>
                    <a:ext uri="{9D8B030D-6E8A-4147-A177-3AD203B41FA5}">
                      <a16:colId xmlns:a16="http://schemas.microsoft.com/office/drawing/2014/main" val="94640887"/>
                    </a:ext>
                  </a:extLst>
                </a:gridCol>
                <a:gridCol w="993224">
                  <a:extLst>
                    <a:ext uri="{9D8B030D-6E8A-4147-A177-3AD203B41FA5}">
                      <a16:colId xmlns:a16="http://schemas.microsoft.com/office/drawing/2014/main" val="752247543"/>
                    </a:ext>
                  </a:extLst>
                </a:gridCol>
                <a:gridCol w="993224">
                  <a:extLst>
                    <a:ext uri="{9D8B030D-6E8A-4147-A177-3AD203B41FA5}">
                      <a16:colId xmlns:a16="http://schemas.microsoft.com/office/drawing/2014/main" val="2075576243"/>
                    </a:ext>
                  </a:extLst>
                </a:gridCol>
                <a:gridCol w="993224">
                  <a:extLst>
                    <a:ext uri="{9D8B030D-6E8A-4147-A177-3AD203B41FA5}">
                      <a16:colId xmlns:a16="http://schemas.microsoft.com/office/drawing/2014/main" val="359054701"/>
                    </a:ext>
                  </a:extLst>
                </a:gridCol>
                <a:gridCol w="993224">
                  <a:extLst>
                    <a:ext uri="{9D8B030D-6E8A-4147-A177-3AD203B41FA5}">
                      <a16:colId xmlns:a16="http://schemas.microsoft.com/office/drawing/2014/main" val="373293690"/>
                    </a:ext>
                  </a:extLst>
                </a:gridCol>
              </a:tblGrid>
              <a:tr h="165154">
                <a:tc>
                  <a:txBody>
                    <a:bodyPr/>
                    <a:lstStyle/>
                    <a:p>
                      <a:pPr algn="ctr"/>
                      <a:r>
                        <a:rPr lang="es-GB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s</a:t>
                      </a: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5%CI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95%CI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_value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R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76063011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4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144577864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ity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82141002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-Cell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84389737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65506139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2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697524135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08858207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M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9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64224270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2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9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81951456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GIT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97114873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 Gamma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94076516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18363695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udin Low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3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392260991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O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3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571392314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2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4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497733261"/>
                  </a:ext>
                </a:extLst>
              </a:tr>
              <a:tr h="178026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lammatory Chemokine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6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005817145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8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065960150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-E score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676950520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B score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85094525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xia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8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105613764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signaling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7046666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2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94563318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071261725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2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968037881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2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73133284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 </a:t>
                      </a:r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al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713877026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mmary Stemnes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550840070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A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640010811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6 expression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955669598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56340655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thelial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16972952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t Cell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06747690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 Beta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95851902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6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472813375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 expression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45010066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6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62365446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 score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7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570519291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tiation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699954153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7-H3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0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341534164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A score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020307592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1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2925480339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R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623507780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D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1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096327056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ness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3628340587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054066133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liferation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1521329751"/>
                  </a:ext>
                </a:extLst>
              </a:tr>
              <a:tr h="1651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</a:t>
                      </a:r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hesion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6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95" marR="3495" marT="2621" marB="2621" anchor="b"/>
                </a:tc>
                <a:extLst>
                  <a:ext uri="{0D108BD9-81ED-4DB2-BD59-A6C34878D82A}">
                    <a16:rowId xmlns:a16="http://schemas.microsoft.com/office/drawing/2014/main" val="8142522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4055791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3CA47D51-B0F5-EC4D-A1E0-AA8C8F164032}"/>
              </a:ext>
            </a:extLst>
          </p:cNvPr>
          <p:cNvSpPr/>
          <p:nvPr/>
        </p:nvSpPr>
        <p:spPr>
          <a:xfrm>
            <a:off x="269873" y="200606"/>
            <a:ext cx="631825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s-GB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7.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earman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sts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atures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minal p-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ries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ltivariable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atures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line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inicopathological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altLang="es-GB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es-E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es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06BEF408-6C50-0849-867E-F18555B17E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75669"/>
            <a:ext cx="6858000" cy="68624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477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>
            <a:extLst>
              <a:ext uri="{FF2B5EF4-FFF2-40B4-BE49-F238E27FC236}">
                <a16:creationId xmlns:a16="http://schemas.microsoft.com/office/drawing/2014/main" id="{E2320C6C-4C7B-F848-BA75-068B0BD38739}"/>
              </a:ext>
            </a:extLst>
          </p:cNvPr>
          <p:cNvSpPr/>
          <p:nvPr/>
        </p:nvSpPr>
        <p:spPr>
          <a:xfrm>
            <a:off x="75665" y="-138878"/>
            <a:ext cx="5868000" cy="5693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b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S1.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east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60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logical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tures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s-ES" sz="10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1">
            <a:extLst>
              <a:ext uri="{FF2B5EF4-FFF2-40B4-BE49-F238E27FC236}">
                <a16:creationId xmlns:a16="http://schemas.microsoft.com/office/drawing/2014/main" id="{8D471F72-40B0-4148-AFDB-6EA05BAEC1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68368085"/>
              </p:ext>
            </p:extLst>
          </p:nvPr>
        </p:nvGraphicFramePr>
        <p:xfrm>
          <a:off x="160506" y="545278"/>
          <a:ext cx="6536987" cy="880310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431755">
                  <a:extLst>
                    <a:ext uri="{9D8B030D-6E8A-4147-A177-3AD203B41FA5}">
                      <a16:colId xmlns:a16="http://schemas.microsoft.com/office/drawing/2014/main" val="3054454825"/>
                    </a:ext>
                  </a:extLst>
                </a:gridCol>
                <a:gridCol w="1729734">
                  <a:extLst>
                    <a:ext uri="{9D8B030D-6E8A-4147-A177-3AD203B41FA5}">
                      <a16:colId xmlns:a16="http://schemas.microsoft.com/office/drawing/2014/main" val="263264913"/>
                    </a:ext>
                  </a:extLst>
                </a:gridCol>
                <a:gridCol w="3375498">
                  <a:extLst>
                    <a:ext uri="{9D8B030D-6E8A-4147-A177-3AD203B41FA5}">
                      <a16:colId xmlns:a16="http://schemas.microsoft.com/office/drawing/2014/main" val="1239002524"/>
                    </a:ext>
                  </a:extLst>
                </a:gridCol>
              </a:tblGrid>
              <a:tr h="139849"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WAY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MMARY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93850594"/>
                  </a:ext>
                </a:extLst>
              </a:tr>
              <a:tr h="70879">
                <a:tc rowSpan="4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 Receptor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671557067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he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trogen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cepto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065836359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 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2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763412044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he progesterone recepto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430857367"/>
                  </a:ext>
                </a:extLst>
              </a:tr>
              <a:tr h="116540">
                <a:tc rowSpan="4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 </a:t>
                      </a:r>
                      <a:r>
                        <a:rPr lang="en-GB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ing</a:t>
                      </a:r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athway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135208562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6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6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649002724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ing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ER mediated signalin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910614281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170105167"/>
                  </a:ext>
                </a:extLst>
              </a:tr>
              <a:tr h="116540">
                <a:tc rowSpan="7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 Subtyping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-Like Correlatio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for Basal-Like subtyp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634569956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udin-Low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subtype characterized by low level of luminal markers, high EM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994794196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-Enriched Correlatio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for HER2-Enriched subtyp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800598832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 A Correlat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fr-F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for LuminalA subtype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181629115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inal B Correlatio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fr-FR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rrelation Coefficient for LuminalB subtype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759489171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M50 Subtyp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-gene signature classifying breast cancer into 4 distinct subtyp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019517190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NBC Subtyp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 identifies 4 distinct TNBC subtyp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535074789"/>
                  </a:ext>
                </a:extLst>
              </a:tr>
              <a:tr h="233081"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east Cancer Prognosi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 Risk of Recurrenc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ses Subtype correlation and PAM50 proliferation score to estimate genomic risk of distant recurrenc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728370618"/>
                  </a:ext>
                </a:extLst>
              </a:tr>
              <a:tr h="116540">
                <a:tc rowSpan="5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e Cell Population Abundanc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-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CD8+ T cells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810061832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cytotoxic cells in tumour microenvironmen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994788919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ce Abundanc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macrophag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280027733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t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mas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9163791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 abundanc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reg abundance by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ing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XP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658728129"/>
                  </a:ext>
                </a:extLst>
              </a:tr>
              <a:tr h="233081"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 Metabolism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xi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genes associated with reduced oxygenation in the tumou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722318536"/>
                  </a:ext>
                </a:extLst>
              </a:tr>
              <a:tr h="123384">
                <a:tc rowSpan="4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 Tumour Mechanism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7-H3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7-H3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921944509"/>
                  </a:ext>
                </a:extLst>
              </a:tr>
              <a:tr h="17067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O1 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Indoleamine 2,3 dioxygenase 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156752567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1 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Program cell death ligand-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758572517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-Beta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-Beta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053177051"/>
                  </a:ext>
                </a:extLst>
              </a:tr>
              <a:tr h="233081">
                <a:tc rowSpan="4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hibitory Tumour </a:t>
                      </a:r>
                      <a:r>
                        <a:rPr lang="en-GB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ing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lammatory Chemokine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chemokines that recruit myeloid and lymphoid populations to tumou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889408756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900420920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2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Program cell death ligand-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522150674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GIT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encoding T cell immunocreceptor and Ig and ITIMS domain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969185176"/>
                  </a:ext>
                </a:extLst>
              </a:tr>
              <a:tr h="233081">
                <a:tc rowSpan="2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l Factors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thelial cell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genes associated with vascular tissue and angiogenesi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121904499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stromal components in the tumour microenvironmen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138521728"/>
                  </a:ext>
                </a:extLst>
              </a:tr>
              <a:tr h="233081"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 Immunogenicity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abundance of genes in MHC Class I antigen presentation pathwa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908226721"/>
                  </a:ext>
                </a:extLst>
              </a:tr>
              <a:tr h="233081">
                <a:tc rowSpan="4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Tumour Immune Activity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it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molecules used by natural killer and CD8+ T cell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082208751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feron gamma signallin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cks the canonical response to I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N gamma</a:t>
                      </a:r>
                      <a:endParaRPr lang="en-GB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06304284"/>
                  </a:ext>
                </a:extLst>
              </a:tr>
              <a:tr h="34962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 class II antigen presentatio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major human leukocyte antigens involved in MHC Class II antigen presentatio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086795421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sures the abundance of a peripherally suppressed adaptive immune response 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774363542"/>
                  </a:ext>
                </a:extLst>
              </a:tr>
              <a:tr h="233081">
                <a:tc rowSpan="3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 Mutational Respons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 </a:t>
                      </a:r>
                      <a:r>
                        <a:rPr lang="en-GB" sz="80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al 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or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 is a surrogate of T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53 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us: higher scores refer to a mutant-like status and lower scores to a wild-type status·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364319995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nes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orms about defects in DNA damage repair-genes BRCA1 and 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105775667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D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 functionally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eses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R repair status· Higher score refers to higher damage repair deficiency·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874704714"/>
                  </a:ext>
                </a:extLst>
              </a:tr>
              <a:tr h="233081">
                <a:tc rowSpan="8">
                  <a:txBody>
                    <a:bodyPr/>
                    <a:lstStyle/>
                    <a:p>
                      <a:pPr marL="54000" lvl="0" algn="l" rtl="0" fontAlgn="ctr"/>
                      <a:r>
                        <a:rPr lang="en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 Regulation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poptosi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ptures genes associated with apoptotic processes, pro- and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apoptotic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gene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3996151992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oliferat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s genes involved in tumour proliferat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270971696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ell Adhe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cores samples for downregulation in tight junction gene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825443261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Differentiation Scor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ssigns a score of differentiation to the sample·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22763428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OXA1 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e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nding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A1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ranscription facto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1196148555"/>
                  </a:ext>
                </a:extLst>
              </a:tr>
              <a:tr h="23308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ammary </a:t>
                      </a:r>
                      <a:r>
                        <a:rPr lang="en-GB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mnes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s a cluster of EMT genes upregulated in stem-cell-like tumour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97218693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1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e encoding retinoblastoma gen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4012775551"/>
                  </a:ext>
                </a:extLst>
              </a:tr>
              <a:tr h="11654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8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2</a:t>
                      </a:r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tc>
                  <a:txBody>
                    <a:bodyPr/>
                    <a:lstStyle/>
                    <a:p>
                      <a:pPr lvl="0" algn="l" rtl="0" fontAlgn="ctr"/>
                      <a:r>
                        <a:rPr lang="en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ene encoding SRY-box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85" marR="5885" marT="5885" marB="0" anchor="ctr"/>
                </a:tc>
                <a:extLst>
                  <a:ext uri="{0D108BD9-81ED-4DB2-BD59-A6C34878D82A}">
                    <a16:rowId xmlns:a16="http://schemas.microsoft.com/office/drawing/2014/main" val="20931655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92314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>
            <a:extLst>
              <a:ext uri="{FF2B5EF4-FFF2-40B4-BE49-F238E27FC236}">
                <a16:creationId xmlns:a16="http://schemas.microsoft.com/office/drawing/2014/main" id="{EC035E9A-FA9C-4642-A184-134B5AC236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717" y="4050372"/>
            <a:ext cx="184731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6834DF62-9532-9540-A835-8C909002775E}"/>
              </a:ext>
            </a:extLst>
          </p:cNvPr>
          <p:cNvSpPr/>
          <p:nvPr/>
        </p:nvSpPr>
        <p:spPr>
          <a:xfrm>
            <a:off x="220717" y="167086"/>
            <a:ext cx="6407111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S2.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mography of the study population</a:t>
            </a:r>
          </a:p>
          <a:p>
            <a:pPr algn="just"/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: number; G: Grade; ILC: Invasive lobular carcinoma; IDC: Invasive ductal carcinoma; ER, Estrogen receptor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esterone receptor, ET, Endocrine Therapy.</a:t>
            </a:r>
            <a:endParaRPr lang="es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05B3C14B-5FBC-4B45-9B1D-DB3C33C037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471141"/>
              </p:ext>
            </p:extLst>
          </p:nvPr>
        </p:nvGraphicFramePr>
        <p:xfrm>
          <a:off x="295448" y="913270"/>
          <a:ext cx="6267104" cy="821695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566776">
                  <a:extLst>
                    <a:ext uri="{9D8B030D-6E8A-4147-A177-3AD203B41FA5}">
                      <a16:colId xmlns:a16="http://schemas.microsoft.com/office/drawing/2014/main" val="2757121014"/>
                    </a:ext>
                  </a:extLst>
                </a:gridCol>
                <a:gridCol w="1566776">
                  <a:extLst>
                    <a:ext uri="{9D8B030D-6E8A-4147-A177-3AD203B41FA5}">
                      <a16:colId xmlns:a16="http://schemas.microsoft.com/office/drawing/2014/main" val="3262006685"/>
                    </a:ext>
                  </a:extLst>
                </a:gridCol>
                <a:gridCol w="1566776">
                  <a:extLst>
                    <a:ext uri="{9D8B030D-6E8A-4147-A177-3AD203B41FA5}">
                      <a16:colId xmlns:a16="http://schemas.microsoft.com/office/drawing/2014/main" val="312840780"/>
                    </a:ext>
                  </a:extLst>
                </a:gridCol>
                <a:gridCol w="1566776">
                  <a:extLst>
                    <a:ext uri="{9D8B030D-6E8A-4147-A177-3AD203B41FA5}">
                      <a16:colId xmlns:a16="http://schemas.microsoft.com/office/drawing/2014/main" val="2423790485"/>
                    </a:ext>
                  </a:extLst>
                </a:gridCol>
              </a:tblGrid>
              <a:tr h="153559"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(n=342)</a:t>
                      </a:r>
                      <a:endParaRPr lang="es-GB" sz="10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ED (n=237)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0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 (n=105)</a:t>
                      </a:r>
                      <a:endParaRPr lang="es-GB" sz="10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711565453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isation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s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3519998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-59 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 (18·1%)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(16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(21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4245033416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69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 (46·5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 (46·4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 (46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391886373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-79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 (25·5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 (26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(22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49330296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80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 (9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(10·1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9·5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44730531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 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 (50-91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 (50-91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 (51-90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028976799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m)</a:t>
                      </a:r>
                      <a:r>
                        <a:rPr lang="es-GB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2081597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≤2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 (4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 (38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 (44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529796347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2 &amp; ≤5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 (54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 (57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 (47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425563984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a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 (0·6-16·5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5 (0·6-8·40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20 (0·8-16·5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983111646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ery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dal Status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725317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 (47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 (44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 (55·2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4244717554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9 (52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 (45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 (44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136301330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e-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gical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ur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rade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163452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1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3·5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4·2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·9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76729696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2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5 (48·2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8 (49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 (44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2180850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3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 (38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 (35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 (43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945428524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 (1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(10·1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(9·5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973187350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ical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3193127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C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(6·1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6·3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5·7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838977780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C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9 (93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 (92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 (94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423525921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inous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·6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·9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727884338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364496308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R status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9150991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ctr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2 (100·</a:t>
                      </a:r>
                      <a:r>
                        <a:rPr lang="es-ES_tradnl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7 (10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 (10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815870070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ctr"/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</a:t>
                      </a:r>
                      <a:r>
                        <a:rPr lang="es-ES_tradnl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927342921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R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tus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35011756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 (46·5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 (46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(45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303133821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 (24·3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(29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 (25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665795428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(29·2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 (23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(28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866379107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urgical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908225046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trozol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 (44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 (64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577144385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strozol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 (24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 (35·4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662738484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 (30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 (10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702820837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GB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y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9704554"/>
                  </a:ext>
                </a:extLst>
              </a:tr>
              <a:tr h="302707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stuzumab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+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7 (60·5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 (57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 (68·5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558539180"/>
                  </a:ext>
                </a:extLst>
              </a:tr>
              <a:tr h="286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on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 (6·7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(6·8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6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63036889"/>
                  </a:ext>
                </a:extLst>
              </a:tr>
              <a:tr h="302707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stuzumab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 (32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 (36·2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 (24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818531058"/>
                  </a:ext>
                </a:extLst>
              </a:tr>
              <a:tr h="153559">
                <a:tc gridSpan="4">
                  <a:txBody>
                    <a:bodyPr/>
                    <a:lstStyle/>
                    <a:p>
                      <a:pPr algn="l"/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</a:t>
                      </a:r>
                      <a:r>
                        <a:rPr lang="es-E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</a:t>
                      </a:r>
                      <a:endParaRPr lang="es-GB" sz="10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0025106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Yes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6 (98·2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3 (98·4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 (98·1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350356703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trozole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4 (50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3 (51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 (48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868594483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strozol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9 (40·6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 (38·4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 (45·7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403292040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emestane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0·3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0·4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363361690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oxife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2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(3·1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·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2376703530"/>
                  </a:ext>
                </a:extLst>
              </a:tr>
              <a:tr h="302707">
                <a:tc>
                  <a:txBody>
                    <a:bodyPr/>
                    <a:lstStyle/>
                    <a:p>
                      <a:pPr algn="r"/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tial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I and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oxife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4·4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(4·6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3·8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946689115"/>
                  </a:ext>
                </a:extLst>
              </a:tr>
              <a:tr h="302707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No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crine</a:t>
                      </a:r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y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1·2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·8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1·9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743197404"/>
                  </a:ext>
                </a:extLst>
              </a:tr>
              <a:tr h="153559">
                <a:tc>
                  <a:txBody>
                    <a:bodyPr/>
                    <a:lstStyle/>
                    <a:p>
                      <a:pPr algn="r"/>
                      <a:r>
                        <a:rPr lang="es-E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known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·6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0·80%)</a:t>
                      </a:r>
                      <a:endParaRPr lang="es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s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604" marR="3604" marT="3604" marB="0" anchor="ctr"/>
                </a:tc>
                <a:extLst>
                  <a:ext uri="{0D108BD9-81ED-4DB2-BD59-A6C34878D82A}">
                    <a16:rowId xmlns:a16="http://schemas.microsoft.com/office/drawing/2014/main" val="15168218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0254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82635C-ED91-4E43-9178-5AF88C5C88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3560" y="407198"/>
            <a:ext cx="6451606" cy="2226536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s-GB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3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analysis of signature expression and response to AI in treated patients (n=227) for the three response categories using ordinal logistic regression models with OR towards poor response and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two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</a:t>
            </a:r>
            <a:r>
              <a:rPr lang="en-US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wks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tegories: high vs low,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variate logistic regression models with OR towards high· In bold FDR values are the significant signatures. </a:t>
            </a:r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R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rogen Receptor 1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ene HER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A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khead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A1;  HRD, Homologous Recombination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gesterone Receptor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D-L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1; Treg, Regulatory T cells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osphatase and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nsi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log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IDO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doleamine 2,3-dioxygenase; AR, Androgen Receptor, IFN Gamma, Interferon Gamma; TIS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lammation Signature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2; TIGIT, T cell immunoreceptor with Ig and ITIM  domain; APM, Antigen Processing Machinery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CAnes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reast Cancer Gene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6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6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F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ansforming growth Factor Bet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blastom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RY(Sex determining region Y)-box2; MHC2, major histocompatibility complex 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cell death protein 1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DK4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4; CD8 T cells, Cytotoxic T lymphocytes; HER2-E, HER2-Enriched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B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A subtype; OR, Odds Ratio; FDR, False discovery rate, CI, Confidence Interval, Ki67</a:t>
            </a:r>
            <a:r>
              <a:rPr lang="en-US" altLang="es-GB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w, 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at 2 weeks timepoint. </a:t>
            </a:r>
            <a:b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a 2">
            <a:extLst>
              <a:ext uri="{FF2B5EF4-FFF2-40B4-BE49-F238E27FC236}">
                <a16:creationId xmlns:a16="http://schemas.microsoft.com/office/drawing/2014/main" id="{E5F45C90-E811-0F43-9398-CC8E7EDDA5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5540058"/>
              </p:ext>
            </p:extLst>
          </p:nvPr>
        </p:nvGraphicFramePr>
        <p:xfrm>
          <a:off x="279700" y="2467479"/>
          <a:ext cx="6314740" cy="6904371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72690">
                  <a:extLst>
                    <a:ext uri="{9D8B030D-6E8A-4147-A177-3AD203B41FA5}">
                      <a16:colId xmlns:a16="http://schemas.microsoft.com/office/drawing/2014/main" val="2096933590"/>
                    </a:ext>
                  </a:extLst>
                </a:gridCol>
                <a:gridCol w="515201">
                  <a:extLst>
                    <a:ext uri="{9D8B030D-6E8A-4147-A177-3AD203B41FA5}">
                      <a16:colId xmlns:a16="http://schemas.microsoft.com/office/drawing/2014/main" val="1878457983"/>
                    </a:ext>
                  </a:extLst>
                </a:gridCol>
                <a:gridCol w="531086">
                  <a:extLst>
                    <a:ext uri="{9D8B030D-6E8A-4147-A177-3AD203B41FA5}">
                      <a16:colId xmlns:a16="http://schemas.microsoft.com/office/drawing/2014/main" val="1811184262"/>
                    </a:ext>
                  </a:extLst>
                </a:gridCol>
                <a:gridCol w="531086">
                  <a:extLst>
                    <a:ext uri="{9D8B030D-6E8A-4147-A177-3AD203B41FA5}">
                      <a16:colId xmlns:a16="http://schemas.microsoft.com/office/drawing/2014/main" val="4112848557"/>
                    </a:ext>
                  </a:extLst>
                </a:gridCol>
                <a:gridCol w="584730">
                  <a:extLst>
                    <a:ext uri="{9D8B030D-6E8A-4147-A177-3AD203B41FA5}">
                      <a16:colId xmlns:a16="http://schemas.microsoft.com/office/drawing/2014/main" val="1606642383"/>
                    </a:ext>
                  </a:extLst>
                </a:gridCol>
                <a:gridCol w="424519">
                  <a:extLst>
                    <a:ext uri="{9D8B030D-6E8A-4147-A177-3AD203B41FA5}">
                      <a16:colId xmlns:a16="http://schemas.microsoft.com/office/drawing/2014/main" val="3960423808"/>
                    </a:ext>
                  </a:extLst>
                </a:gridCol>
                <a:gridCol w="584730">
                  <a:extLst>
                    <a:ext uri="{9D8B030D-6E8A-4147-A177-3AD203B41FA5}">
                      <a16:colId xmlns:a16="http://schemas.microsoft.com/office/drawing/2014/main" val="1733316537"/>
                    </a:ext>
                  </a:extLst>
                </a:gridCol>
                <a:gridCol w="520357">
                  <a:extLst>
                    <a:ext uri="{9D8B030D-6E8A-4147-A177-3AD203B41FA5}">
                      <a16:colId xmlns:a16="http://schemas.microsoft.com/office/drawing/2014/main" val="2414003393"/>
                    </a:ext>
                  </a:extLst>
                </a:gridCol>
                <a:gridCol w="552543">
                  <a:extLst>
                    <a:ext uri="{9D8B030D-6E8A-4147-A177-3AD203B41FA5}">
                      <a16:colId xmlns:a16="http://schemas.microsoft.com/office/drawing/2014/main" val="3074606536"/>
                    </a:ext>
                  </a:extLst>
                </a:gridCol>
                <a:gridCol w="498899">
                  <a:extLst>
                    <a:ext uri="{9D8B030D-6E8A-4147-A177-3AD203B41FA5}">
                      <a16:colId xmlns:a16="http://schemas.microsoft.com/office/drawing/2014/main" val="2228174797"/>
                    </a:ext>
                  </a:extLst>
                </a:gridCol>
                <a:gridCol w="498899">
                  <a:extLst>
                    <a:ext uri="{9D8B030D-6E8A-4147-A177-3AD203B41FA5}">
                      <a16:colId xmlns:a16="http://schemas.microsoft.com/office/drawing/2014/main" val="1525158286"/>
                    </a:ext>
                  </a:extLst>
                </a:gridCol>
              </a:tblGrid>
              <a:tr h="358029"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gnature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3810" marT="107950" marB="107950" anchor="b"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i67</a:t>
                      </a:r>
                      <a:r>
                        <a:rPr lang="es-ES" sz="800" b="1" baseline="-25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wks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107950" marB="10795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i67 response categories 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T="107950" marB="10795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1502664"/>
                  </a:ext>
                </a:extLst>
              </a:tr>
              <a:tr h="254254">
                <a:tc>
                  <a:txBody>
                    <a:bodyPr/>
                    <a:lstStyle/>
                    <a:p>
                      <a:pPr algn="ctr"/>
                      <a:endParaRPr lang="es-GB" sz="8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95%CI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pper</a:t>
                      </a: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95%CI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D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wer 95%CI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pper 95%CI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D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233277780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ER2-E score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0·5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·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1·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·3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·0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·4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18900426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SR1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573619562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R-Signaling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00436146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RBB2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171196278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umB score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08859773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53 </a:t>
                      </a:r>
                      <a:r>
                        <a:rPr lang="es-ES" sz="800" b="1" i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ional</a:t>
                      </a:r>
                      <a:r>
                        <a:rPr lang="es-ES" sz="8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core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·1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·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·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6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·0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168032567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asal score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0·3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3·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19·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·0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0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·6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26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29614712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XA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46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40870986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umA score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3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7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8305589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optosi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3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7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25667425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RD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·5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·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3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8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6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26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68905138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G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7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08111886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ypoxia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8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·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50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1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6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9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91727605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liferation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·3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·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0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5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60479612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omic Risk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3699935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DO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160339768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FN Gamma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75687388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2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56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7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933584585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L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2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71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5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488106462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3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73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6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9123247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dothelial Cell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3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80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555441752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L2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0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2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7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94002687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eg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20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8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86562296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crophage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2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3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70730342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M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2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3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3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685915977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ytotoxicity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3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6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85634868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GIT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77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491789759"/>
                  </a:ext>
                </a:extLst>
              </a:tr>
              <a:tr h="2542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ammatory</a:t>
                      </a: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emokines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83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6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3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525037499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ytotoxic</a:t>
                      </a: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5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084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75664730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TEN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1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24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8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229676670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X2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4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93847502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t Cell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46530587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8-T-Cell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4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2723940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RCAness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5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7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8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9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5333902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K6 </a:t>
                      </a:r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5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7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9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8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181118510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audin Low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5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7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19150862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7-H3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6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8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6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06898605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F-Beta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6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323663246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oma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6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622013209"/>
                  </a:ext>
                </a:extLst>
              </a:tr>
              <a:tr h="254254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mmary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emness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9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280243951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D-1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4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2485608794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K4</a:t>
                      </a:r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expression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5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·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·1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263822187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b1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3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2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2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317397356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fferentiation</a:t>
                      </a:r>
                      <a:endParaRPr lang="es-GB" sz="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5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2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0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17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1056299393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HC2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5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9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0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7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38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4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61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291851902"/>
                  </a:ext>
                </a:extLst>
              </a:tr>
              <a:tr h="129077">
                <a:tc>
                  <a:txBody>
                    <a:bodyPr/>
                    <a:lstStyle/>
                    <a:p>
                      <a:pPr algn="r"/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</a:t>
                      </a: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hesion</a:t>
                      </a:r>
                      <a:endParaRPr lang="es-GB" sz="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9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03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4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·2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76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·80</a:t>
                      </a:r>
                    </a:p>
                  </a:txBody>
                  <a:tcPr marL="3810" marR="3810" marT="3810" marB="0" anchor="b"/>
                </a:tc>
                <a:extLst>
                  <a:ext uri="{0D108BD9-81ED-4DB2-BD59-A6C34878D82A}">
                    <a16:rowId xmlns:a16="http://schemas.microsoft.com/office/drawing/2014/main" val="40947746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3747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6200572C-9702-C64C-A472-A7D2EDEE387F}"/>
              </a:ext>
            </a:extLst>
          </p:cNvPr>
          <p:cNvSpPr txBox="1"/>
          <p:nvPr/>
        </p:nvSpPr>
        <p:spPr>
          <a:xfrm>
            <a:off x="359595" y="176947"/>
            <a:ext cx="6226139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4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analysis of signature expression and response to AI in treated patients (n=227) for the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response categories: &gt;20% vs &lt;20%,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variate logistic regression models with OR towards high. </a:t>
            </a:r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R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strogen Receptor 1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ene HER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A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khead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A1;  HRD, Homologous Recombination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gesterone Receptor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PD-L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1; Treg, Regulatory T cells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TE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osphatase and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nsin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log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IDO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doleamine 2,3-dioxygenase; AR, Androgen Receptor, IFN Gamma, Interferon Gamma; TIS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u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lammation Signature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death-ligand 2; TIGIT, T cell immunoreceptor with Ig and ITIM  domain; APM, Antigen Processing Machinery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CAnes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reast Cancer Gene deficiency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6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6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F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ansforming growth Factor Bet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blastoma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RY(Sex determining region Y)-box2; MHC2, major histocompatibility complex 2; 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1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ogrammed cell death protein 1</a:t>
            </a:r>
            <a:r>
              <a:rPr lang="en-US" altLang="es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DK4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yclin-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endant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inase 4; CD8 T cells, Cytotoxic T lymphocytes; HER2-E, HER2-Enriched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B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A subtype; OR, Odds Ratio; FDR, False discovery rate, CI, Confidence Interval, Ki67</a:t>
            </a:r>
            <a:r>
              <a:rPr lang="en-US" altLang="es-GB" sz="10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w, 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at 2 weeks timepoint.</a:t>
            </a:r>
          </a:p>
          <a:p>
            <a:pPr algn="just"/>
            <a:b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1000" dirty="0"/>
          </a:p>
        </p:txBody>
      </p:sp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id="{0AC5F75D-4045-8444-BBFC-C04C38637F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0875473"/>
              </p:ext>
            </p:extLst>
          </p:nvPr>
        </p:nvGraphicFramePr>
        <p:xfrm>
          <a:off x="793728" y="2418352"/>
          <a:ext cx="5270544" cy="7310701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33073">
                  <a:extLst>
                    <a:ext uri="{9D8B030D-6E8A-4147-A177-3AD203B41FA5}">
                      <a16:colId xmlns:a16="http://schemas.microsoft.com/office/drawing/2014/main" val="1537277267"/>
                    </a:ext>
                  </a:extLst>
                </a:gridCol>
                <a:gridCol w="882563">
                  <a:extLst>
                    <a:ext uri="{9D8B030D-6E8A-4147-A177-3AD203B41FA5}">
                      <a16:colId xmlns:a16="http://schemas.microsoft.com/office/drawing/2014/main" val="1792658417"/>
                    </a:ext>
                  </a:extLst>
                </a:gridCol>
                <a:gridCol w="771574">
                  <a:extLst>
                    <a:ext uri="{9D8B030D-6E8A-4147-A177-3AD203B41FA5}">
                      <a16:colId xmlns:a16="http://schemas.microsoft.com/office/drawing/2014/main" val="96350690"/>
                    </a:ext>
                  </a:extLst>
                </a:gridCol>
                <a:gridCol w="705426">
                  <a:extLst>
                    <a:ext uri="{9D8B030D-6E8A-4147-A177-3AD203B41FA5}">
                      <a16:colId xmlns:a16="http://schemas.microsoft.com/office/drawing/2014/main" val="168649153"/>
                    </a:ext>
                  </a:extLst>
                </a:gridCol>
                <a:gridCol w="1020349">
                  <a:extLst>
                    <a:ext uri="{9D8B030D-6E8A-4147-A177-3AD203B41FA5}">
                      <a16:colId xmlns:a16="http://schemas.microsoft.com/office/drawing/2014/main" val="2662896499"/>
                    </a:ext>
                  </a:extLst>
                </a:gridCol>
                <a:gridCol w="657559">
                  <a:extLst>
                    <a:ext uri="{9D8B030D-6E8A-4147-A177-3AD203B41FA5}">
                      <a16:colId xmlns:a16="http://schemas.microsoft.com/office/drawing/2014/main" val="2575205497"/>
                    </a:ext>
                  </a:extLst>
                </a:gridCol>
              </a:tblGrid>
              <a:tr h="292973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ture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5%CI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5%CI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R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719814830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aling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0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5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·7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993961595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R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6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9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777338544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B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·7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·8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·9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37670052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2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538627856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R2E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86825899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al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021485323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oxia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648017422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R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687471756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mA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·4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4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·7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1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99060972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/>
                      <a:r>
                        <a:rPr lang="es-ES" sz="8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53 </a:t>
                      </a:r>
                      <a:r>
                        <a:rPr lang="es-ES" sz="800" b="1" i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ional</a:t>
                      </a:r>
                      <a:r>
                        <a:rPr lang="es-ES" sz="8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core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·11</a:t>
                      </a:r>
                    </a:p>
                  </a:txBody>
                  <a:tcPr marL="3810" marR="3810" marT="381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·00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8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388017128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CAness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4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9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933867600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6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5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0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22687298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D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5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0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129815725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XA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8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34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481855682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st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9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39</a:t>
                      </a:r>
                      <a:endParaRPr lang="es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483895600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optosi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7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·7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7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020978043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O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3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0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536761147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liferation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49762513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K4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ression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1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·4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7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05153905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EN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8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9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9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126506379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ma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0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547904433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omic Risk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171030644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tiation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1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722608835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M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925289838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g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914092398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ity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673054657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894033892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4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0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542715418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936664064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toxic Cells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483757713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849541832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GIT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74536656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udin-Low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129478366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 Gamma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588910440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mmary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emnes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362541495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X2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4225106929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F-Beta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0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120313335"/>
                  </a:ext>
                </a:extLst>
              </a:tr>
              <a:tr h="292973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lammatory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kine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922417707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L2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1743532670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D-1</a:t>
                      </a:r>
                      <a:endParaRPr lang="es-ES" sz="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1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322085147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thelial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8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1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07440185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7-H</a:t>
                      </a:r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0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3839972481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HC2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4148095344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Adhesion</a:t>
                      </a:r>
                      <a:endParaRPr lang="es-E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6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3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453025865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8 T-</a:t>
                      </a:r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5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7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623675488"/>
                  </a:ext>
                </a:extLst>
              </a:tr>
              <a:tr h="149439">
                <a:tc>
                  <a:txBody>
                    <a:bodyPr/>
                    <a:lstStyle/>
                    <a:p>
                      <a:pPr algn="r" fontAlgn="b"/>
                      <a:r>
                        <a:rPr lang="es-ES" sz="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phages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4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9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GB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0</a:t>
                      </a:r>
                      <a:endParaRPr lang="es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68" marR="6268" marT="6268" marB="0" anchor="b"/>
                </a:tc>
                <a:extLst>
                  <a:ext uri="{0D108BD9-81ED-4DB2-BD59-A6C34878D82A}">
                    <a16:rowId xmlns:a16="http://schemas.microsoft.com/office/drawing/2014/main" val="27173452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5549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ángulo 16">
            <a:extLst>
              <a:ext uri="{FF2B5EF4-FFF2-40B4-BE49-F238E27FC236}">
                <a16:creationId xmlns:a16="http://schemas.microsoft.com/office/drawing/2014/main" id="{206AD81D-D5F0-5A4F-AB1B-391DCA2BB81F}"/>
              </a:ext>
            </a:extLst>
          </p:cNvPr>
          <p:cNvSpPr/>
          <p:nvPr/>
        </p:nvSpPr>
        <p:spPr>
          <a:xfrm>
            <a:off x="43362" y="87984"/>
            <a:ext cx="6474555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2.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ifferential signature expression by subtypes including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2-E BC (n=95) and Luminal BC tumours (n=128)·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terplots show th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gOR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the logistic regression models calculated for the expression of the 46 signatures for a. Ki67 response categories and b. Ki67 2 weeks categories. </a:t>
            </a:r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ER2-E, HER2-Enriched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B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A; OR, Odds Ratio.</a:t>
            </a:r>
          </a:p>
          <a:p>
            <a:pPr algn="just"/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GB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8">
            <a:extLst>
              <a:ext uri="{FF2B5EF4-FFF2-40B4-BE49-F238E27FC236}">
                <a16:creationId xmlns:a16="http://schemas.microsoft.com/office/drawing/2014/main" id="{E4D73969-5911-674E-95B1-7C1E2656BE95}"/>
              </a:ext>
            </a:extLst>
          </p:cNvPr>
          <p:cNvSpPr txBox="1"/>
          <p:nvPr/>
        </p:nvSpPr>
        <p:spPr>
          <a:xfrm>
            <a:off x="82868" y="1072046"/>
            <a:ext cx="4765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9" name="TextBox 8">
            <a:extLst>
              <a:ext uri="{FF2B5EF4-FFF2-40B4-BE49-F238E27FC236}">
                <a16:creationId xmlns:a16="http://schemas.microsoft.com/office/drawing/2014/main" id="{202251FF-187A-9B48-A66C-B6F9414955C5}"/>
              </a:ext>
            </a:extLst>
          </p:cNvPr>
          <p:cNvSpPr txBox="1"/>
          <p:nvPr/>
        </p:nvSpPr>
        <p:spPr>
          <a:xfrm>
            <a:off x="3210238" y="1072046"/>
            <a:ext cx="3030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90E2B3E7-8D75-A245-9BF7-98669CBE7E3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616" t="31452" r="13965"/>
          <a:stretch/>
        </p:blipFill>
        <p:spPr>
          <a:xfrm>
            <a:off x="6336269" y="1695575"/>
            <a:ext cx="510821" cy="451591"/>
          </a:xfrm>
          <a:prstGeom prst="rect">
            <a:avLst/>
          </a:prstGeom>
        </p:spPr>
      </p:pic>
      <p:sp>
        <p:nvSpPr>
          <p:cNvPr id="21" name="Elipse 20">
            <a:extLst>
              <a:ext uri="{FF2B5EF4-FFF2-40B4-BE49-F238E27FC236}">
                <a16:creationId xmlns:a16="http://schemas.microsoft.com/office/drawing/2014/main" id="{4FBEF904-F4E4-2A4C-9A97-3C4D844DD576}"/>
              </a:ext>
            </a:extLst>
          </p:cNvPr>
          <p:cNvSpPr/>
          <p:nvPr/>
        </p:nvSpPr>
        <p:spPr>
          <a:xfrm>
            <a:off x="6154903" y="3302085"/>
            <a:ext cx="18000" cy="180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id="{CD05E3F4-6127-7C48-8FF9-98D70956FD2A}"/>
              </a:ext>
            </a:extLst>
          </p:cNvPr>
          <p:cNvSpPr/>
          <p:nvPr/>
        </p:nvSpPr>
        <p:spPr>
          <a:xfrm>
            <a:off x="159212" y="4293527"/>
            <a:ext cx="6504036" cy="5693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3· </a:t>
            </a:r>
            <a:r>
              <a:rPr lang="en-US" sz="10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R1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expression levels by PAM50 intrinsic subtype and </a:t>
            </a:r>
            <a:r>
              <a:rPr lang="en-US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ured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y different levels (</a:t>
            </a:r>
            <a:r>
              <a:rPr lang="en-US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rtiles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f </a:t>
            </a:r>
            <a:r>
              <a:rPr lang="en-US" sz="10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e expression. </a:t>
            </a:r>
            <a:r>
              <a:rPr lang="en-US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: 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R2-E, HER2-Enriched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B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A subtype; T,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tile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E43AF610-910F-AB43-A262-1C9FA67CB26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1795"/>
          <a:stretch/>
        </p:blipFill>
        <p:spPr>
          <a:xfrm>
            <a:off x="82868" y="1355447"/>
            <a:ext cx="3065734" cy="2457672"/>
          </a:xfrm>
          <a:prstGeom prst="rect">
            <a:avLst/>
          </a:prstGeom>
        </p:spPr>
      </p:pic>
      <p:sp>
        <p:nvSpPr>
          <p:cNvPr id="6" name="Elipse 5">
            <a:extLst>
              <a:ext uri="{FF2B5EF4-FFF2-40B4-BE49-F238E27FC236}">
                <a16:creationId xmlns:a16="http://schemas.microsoft.com/office/drawing/2014/main" id="{EE37B3C8-0376-ED4F-A8A6-C7978E4C81A8}"/>
              </a:ext>
            </a:extLst>
          </p:cNvPr>
          <p:cNvSpPr/>
          <p:nvPr/>
        </p:nvSpPr>
        <p:spPr>
          <a:xfrm flipH="1" flipV="1">
            <a:off x="6399608" y="1978305"/>
            <a:ext cx="36000" cy="36000"/>
          </a:xfrm>
          <a:prstGeom prst="ellips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95E1170F-7B9A-8A46-A581-A7D95511BB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0777"/>
          <a:stretch/>
        </p:blipFill>
        <p:spPr>
          <a:xfrm>
            <a:off x="3222060" y="1344525"/>
            <a:ext cx="3116036" cy="2468594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565DC170-1025-DE4A-995F-85A419FBE771}"/>
              </a:ext>
            </a:extLst>
          </p:cNvPr>
          <p:cNvSpPr txBox="1"/>
          <p:nvPr/>
        </p:nvSpPr>
        <p:spPr>
          <a:xfrm>
            <a:off x="6326306" y="1541221"/>
            <a:ext cx="5207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0·05</a:t>
            </a: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16E2E7CF-5613-4643-9502-BFFC704DA1D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4496" y="4970482"/>
            <a:ext cx="6858000" cy="4847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78091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>
            <a:extLst>
              <a:ext uri="{FF2B5EF4-FFF2-40B4-BE49-F238E27FC236}">
                <a16:creationId xmlns:a16="http://schemas.microsoft.com/office/drawing/2014/main" id="{DA1787B0-FC32-BA4F-8733-828BC25793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0839" y="165150"/>
            <a:ext cx="6396321" cy="569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s-GB" sz="1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t</a:t>
            </a:r>
            <a:r>
              <a:rPr kumimoji="0" lang="en-US" altLang="es-GB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le S5. 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ociation analysis of the new molecular subgroups based on single gene expression and response to AI by different </a:t>
            </a:r>
            <a:r>
              <a:rPr lang="en-US" altLang="es-GB" sz="1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dpoints.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s-GB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</a:t>
            </a:r>
            <a:r>
              <a:rPr kumimoji="0" lang="en-US" altLang="es-GB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R, Good Response, IR: Intermediate Response, PR: Poor response.</a:t>
            </a:r>
          </a:p>
        </p:txBody>
      </p:sp>
      <p:graphicFrame>
        <p:nvGraphicFramePr>
          <p:cNvPr id="3" name="Tabla 2">
            <a:extLst>
              <a:ext uri="{FF2B5EF4-FFF2-40B4-BE49-F238E27FC236}">
                <a16:creationId xmlns:a16="http://schemas.microsoft.com/office/drawing/2014/main" id="{AD64B985-CEDA-8B40-9DE1-5D98E94033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399011"/>
              </p:ext>
            </p:extLst>
          </p:nvPr>
        </p:nvGraphicFramePr>
        <p:xfrm>
          <a:off x="404404" y="826694"/>
          <a:ext cx="6065940" cy="255973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010990">
                  <a:extLst>
                    <a:ext uri="{9D8B030D-6E8A-4147-A177-3AD203B41FA5}">
                      <a16:colId xmlns:a16="http://schemas.microsoft.com/office/drawing/2014/main" val="4098374338"/>
                    </a:ext>
                  </a:extLst>
                </a:gridCol>
                <a:gridCol w="1010990">
                  <a:extLst>
                    <a:ext uri="{9D8B030D-6E8A-4147-A177-3AD203B41FA5}">
                      <a16:colId xmlns:a16="http://schemas.microsoft.com/office/drawing/2014/main" val="544196737"/>
                    </a:ext>
                  </a:extLst>
                </a:gridCol>
                <a:gridCol w="1010990">
                  <a:extLst>
                    <a:ext uri="{9D8B030D-6E8A-4147-A177-3AD203B41FA5}">
                      <a16:colId xmlns:a16="http://schemas.microsoft.com/office/drawing/2014/main" val="239769409"/>
                    </a:ext>
                  </a:extLst>
                </a:gridCol>
                <a:gridCol w="1010990">
                  <a:extLst>
                    <a:ext uri="{9D8B030D-6E8A-4147-A177-3AD203B41FA5}">
                      <a16:colId xmlns:a16="http://schemas.microsoft.com/office/drawing/2014/main" val="1792823726"/>
                    </a:ext>
                  </a:extLst>
                </a:gridCol>
                <a:gridCol w="1010990">
                  <a:extLst>
                    <a:ext uri="{9D8B030D-6E8A-4147-A177-3AD203B41FA5}">
                      <a16:colId xmlns:a16="http://schemas.microsoft.com/office/drawing/2014/main" val="2896328421"/>
                    </a:ext>
                  </a:extLst>
                </a:gridCol>
                <a:gridCol w="1010990">
                  <a:extLst>
                    <a:ext uri="{9D8B030D-6E8A-4147-A177-3AD203B41FA5}">
                      <a16:colId xmlns:a16="http://schemas.microsoft.com/office/drawing/2014/main" val="1317120049"/>
                    </a:ext>
                  </a:extLst>
                </a:gridCol>
              </a:tblGrid>
              <a:tr h="232703">
                <a:tc>
                  <a:txBody>
                    <a:bodyPr/>
                    <a:lstStyle/>
                    <a:p>
                      <a:pPr algn="l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gle gene </a:t>
                      </a:r>
                      <a:r>
                        <a:rPr lang="es-ES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ed</a:t>
                      </a:r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s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045648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l" rtl="0" fontAlgn="ctr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2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4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s-GB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5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80127101"/>
                  </a:ext>
                </a:extLst>
              </a:tr>
              <a:tr h="232703">
                <a:tc gridSpan="6">
                  <a:txBody>
                    <a:bodyPr/>
                    <a:lstStyle/>
                    <a:p>
                      <a:pPr marL="54000" algn="l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e </a:t>
                      </a:r>
                      <a:r>
                        <a:rPr lang="es-ES" sz="9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ies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3379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GR 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22·7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18·8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(30·7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 (52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29·2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33223125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IR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21·3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28·1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(9·4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16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26·2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97072731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PR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 (56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(53·1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46·2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(32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 (44·6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48264065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l" rtl="0" fontAlgn="ctr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5">
                  <a:txBody>
                    <a:bodyPr/>
                    <a:lstStyle/>
                    <a:p>
                      <a:pPr algn="r" rtl="0" fontAlgn="ctr"/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-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red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stics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5·9263, p-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·043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08256367"/>
                  </a:ext>
                </a:extLst>
              </a:tr>
              <a:tr h="232703">
                <a:tc gridSpan="6">
                  <a:txBody>
                    <a:bodyPr/>
                    <a:lstStyle/>
                    <a:p>
                      <a:pPr marL="54000" algn="l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67</a:t>
                      </a:r>
                      <a:r>
                        <a:rPr lang="es-ES" sz="900" b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wks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434046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LOW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23·7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29·1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38·5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 (70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 (67·7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73489960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ES" sz="9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HIGH</a:t>
                      </a:r>
                      <a:endParaRPr lang="es-E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 (77·3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 (71·9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61·5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30·0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(32·3%)</a:t>
                      </a:r>
                      <a:endParaRPr lang="es-GB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54526664"/>
                  </a:ext>
                </a:extLst>
              </a:tr>
              <a:tr h="232703">
                <a:tc>
                  <a:txBody>
                    <a:bodyPr/>
                    <a:lstStyle/>
                    <a:p>
                      <a:pPr algn="r" rtl="0" fontAlgn="ctr"/>
                      <a:r>
                        <a:rPr lang="es-GB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5">
                  <a:txBody>
                    <a:bodyPr/>
                    <a:lstStyle/>
                    <a:p>
                      <a:pPr algn="r" rtl="0" fontAlgn="b"/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-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red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stics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2·23, p-</a:t>
                      </a:r>
                      <a:r>
                        <a:rPr lang="es-ES" sz="9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r>
                        <a:rPr lang="es-ES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·0001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2954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857323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01A7C371-835D-014F-8DC0-4322EE4A1090}"/>
              </a:ext>
            </a:extLst>
          </p:cNvPr>
          <p:cNvSpPr txBox="1"/>
          <p:nvPr/>
        </p:nvSpPr>
        <p:spPr>
          <a:xfrm>
            <a:off x="138823" y="168509"/>
            <a:ext cx="6643416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expression of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67 percentage changes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R1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the 5 new subgroups in the entire cohort. </a:t>
            </a:r>
            <a:r>
              <a:rPr lang="en-US" alt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, Cluster; HER2-E, HER2-Enriched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B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B subtype;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mA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uminal A subtype.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43BEF944-2D45-664D-9CC1-674E66B55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662769" y="1059103"/>
            <a:ext cx="3021981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>
                <a:tab pos="4829175" algn="l"/>
              </a:tabLst>
            </a:pPr>
            <a:r>
              <a:rPr kumimoji="0" lang="en-GB" altLang="es-GB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                                                      A·</a:t>
            </a:r>
            <a:endParaRPr kumimoji="0" lang="en-GB" altLang="es-GB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829175" algn="l"/>
              </a:tabLst>
            </a:pPr>
            <a:endParaRPr kumimoji="0" lang="en-GB" altLang="es-GB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3">
            <a:extLst>
              <a:ext uri="{FF2B5EF4-FFF2-40B4-BE49-F238E27FC236}">
                <a16:creationId xmlns:a16="http://schemas.microsoft.com/office/drawing/2014/main" id="{C2001C3D-BFA8-D540-A1C7-5568DE1C05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390" y="1059103"/>
            <a:ext cx="2956259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>
                <a:tab pos="4829175" algn="l"/>
              </a:tabLst>
            </a:pPr>
            <a:r>
              <a:rPr kumimoji="0" lang="en-GB" altLang="es-GB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                                                    B·</a:t>
            </a:r>
            <a:endParaRPr kumimoji="0" lang="en-GB" altLang="es-GB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829175" algn="l"/>
              </a:tabLst>
            </a:pPr>
            <a:endParaRPr kumimoji="0" lang="en-GB" altLang="es-GB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Rectangle 3">
            <a:extLst>
              <a:ext uri="{FF2B5EF4-FFF2-40B4-BE49-F238E27FC236}">
                <a16:creationId xmlns:a16="http://schemas.microsoft.com/office/drawing/2014/main" id="{3B013CFA-5F80-BB4F-916D-292C2CD3CF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2597047" y="3994339"/>
            <a:ext cx="2956259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482917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>
                <a:tab pos="4829175" algn="l"/>
              </a:tabLst>
            </a:pPr>
            <a:r>
              <a:rPr kumimoji="0" lang="en-GB" altLang="es-GB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                                                       C·</a:t>
            </a:r>
            <a:endParaRPr kumimoji="0" lang="en-GB" altLang="es-GB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4829175" algn="l"/>
              </a:tabLst>
            </a:pPr>
            <a:endParaRPr kumimoji="0" lang="en-GB" altLang="es-GB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238D0367-EA97-9D42-ADDB-BFE74B3D0E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4755" y="4444442"/>
            <a:ext cx="1465668" cy="2190206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2C818127-B076-9844-95D3-E4130DB887D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3505"/>
          <a:stretch/>
        </p:blipFill>
        <p:spPr>
          <a:xfrm>
            <a:off x="83177" y="1267205"/>
            <a:ext cx="3345823" cy="2734233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4D9AC14D-5177-EC4A-8C99-E9774CD5D48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9238"/>
          <a:stretch/>
        </p:blipFill>
        <p:spPr>
          <a:xfrm>
            <a:off x="3613649" y="1224052"/>
            <a:ext cx="3124063" cy="2734233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5AD365AB-10DB-BA45-A23F-846D6AE478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753"/>
          <a:stretch/>
        </p:blipFill>
        <p:spPr>
          <a:xfrm>
            <a:off x="83177" y="4645444"/>
            <a:ext cx="3607026" cy="27342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96446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ángulo 7">
            <a:extLst>
              <a:ext uri="{FF2B5EF4-FFF2-40B4-BE49-F238E27FC236}">
                <a16:creationId xmlns:a16="http://schemas.microsoft.com/office/drawing/2014/main" id="{DF01FC6E-BF9F-5B4C-BA18-8BF8B34E424C}"/>
              </a:ext>
            </a:extLst>
          </p:cNvPr>
          <p:cNvSpPr/>
          <p:nvPr/>
        </p:nvSpPr>
        <p:spPr>
          <a:xfrm>
            <a:off x="162485" y="112469"/>
            <a:ext cx="6533029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6.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variable cox regression analysis for TTR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ed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gnosis </a:t>
            </a:r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 variables driving differential adjuvant chemotherapy and HER2 treatment choice</a:t>
            </a:r>
            <a:r>
              <a:rPr 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</a:t>
            </a:r>
            <a:r>
              <a:rPr 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, Hazard Ratio; FDR, False discovery rate, CI: Confidence Interval; N, nodal; EMC: Extra </a:t>
            </a:r>
            <a:r>
              <a:rPr lang="en-US" altLang="es-GB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ular</a:t>
            </a:r>
            <a:r>
              <a:rPr lang="en-US" altLang="es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rix, HER2-E, HER2-enriched.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a 2">
            <a:extLst>
              <a:ext uri="{FF2B5EF4-FFF2-40B4-BE49-F238E27FC236}">
                <a16:creationId xmlns:a16="http://schemas.microsoft.com/office/drawing/2014/main" id="{0C1A11BD-5896-D14D-AAE6-35CFC6C269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0032215"/>
              </p:ext>
            </p:extLst>
          </p:nvPr>
        </p:nvGraphicFramePr>
        <p:xfrm>
          <a:off x="471112" y="904601"/>
          <a:ext cx="5777075" cy="768531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69793">
                  <a:extLst>
                    <a:ext uri="{9D8B030D-6E8A-4147-A177-3AD203B41FA5}">
                      <a16:colId xmlns:a16="http://schemas.microsoft.com/office/drawing/2014/main" val="2769087470"/>
                    </a:ext>
                  </a:extLst>
                </a:gridCol>
                <a:gridCol w="1269793">
                  <a:extLst>
                    <a:ext uri="{9D8B030D-6E8A-4147-A177-3AD203B41FA5}">
                      <a16:colId xmlns:a16="http://schemas.microsoft.com/office/drawing/2014/main" val="2041411958"/>
                    </a:ext>
                  </a:extLst>
                </a:gridCol>
                <a:gridCol w="659129">
                  <a:extLst>
                    <a:ext uri="{9D8B030D-6E8A-4147-A177-3AD203B41FA5}">
                      <a16:colId xmlns:a16="http://schemas.microsoft.com/office/drawing/2014/main" val="98136129"/>
                    </a:ext>
                  </a:extLst>
                </a:gridCol>
                <a:gridCol w="726982">
                  <a:extLst>
                    <a:ext uri="{9D8B030D-6E8A-4147-A177-3AD203B41FA5}">
                      <a16:colId xmlns:a16="http://schemas.microsoft.com/office/drawing/2014/main" val="1561411404"/>
                    </a:ext>
                  </a:extLst>
                </a:gridCol>
                <a:gridCol w="726982">
                  <a:extLst>
                    <a:ext uri="{9D8B030D-6E8A-4147-A177-3AD203B41FA5}">
                      <a16:colId xmlns:a16="http://schemas.microsoft.com/office/drawing/2014/main" val="986634591"/>
                    </a:ext>
                  </a:extLst>
                </a:gridCol>
                <a:gridCol w="562198">
                  <a:extLst>
                    <a:ext uri="{9D8B030D-6E8A-4147-A177-3AD203B41FA5}">
                      <a16:colId xmlns:a16="http://schemas.microsoft.com/office/drawing/2014/main" val="799888085"/>
                    </a:ext>
                  </a:extLst>
                </a:gridCol>
                <a:gridCol w="562198">
                  <a:extLst>
                    <a:ext uri="{9D8B030D-6E8A-4147-A177-3AD203B41FA5}">
                      <a16:colId xmlns:a16="http://schemas.microsoft.com/office/drawing/2014/main" val="969452286"/>
                    </a:ext>
                  </a:extLst>
                </a:gridCol>
              </a:tblGrid>
              <a:tr h="192914">
                <a:tc rowSpan="8"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1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r>
                        <a:rPr lang="es-GB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 CI 95%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CI 95%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 b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655797117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gt;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2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49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6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368533358"/>
                  </a:ext>
                </a:extLst>
              </a:tr>
              <a:tr h="1082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1-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7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957995731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4+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·9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639966342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siz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·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960725781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868772364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8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·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633891035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kekihood Chi square ratio test: 30·48 on 6 df, p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0650322"/>
                  </a:ext>
                </a:extLst>
              </a:tr>
              <a:tr h="192914">
                <a:tc rowSpan="9">
                  <a:txBody>
                    <a:bodyPr/>
                    <a:lstStyle/>
                    <a:p>
                      <a:pPr algn="ctr"/>
                      <a:r>
                        <a:rPr lang="es-ES" sz="8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lang="es-GB" sz="800" b="1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 CI 95%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per CI 95%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58042561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gt;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4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7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87438649"/>
                  </a:ext>
                </a:extLst>
              </a:tr>
              <a:tr h="1082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1-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618779048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4+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6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·7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486979845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siz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03023296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7184586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0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512419704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insic subtype: HER2-E  vs Luminals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9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5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·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762854955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r"/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kekihood Chi square ratio test: 34·2 on 7 df, p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318994"/>
                  </a:ext>
                </a:extLst>
              </a:tr>
              <a:tr h="97660">
                <a:tc rowSpan="11"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3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gt;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2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4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4183127334"/>
                  </a:ext>
                </a:extLst>
              </a:tr>
              <a:tr h="1082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1-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388260322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4+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8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·5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07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37908369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siz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4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797716793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307825158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8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9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7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8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·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269201646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2 EMC + highest ERBB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8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9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·0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0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4175630138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3 DNA-damage repair deficiency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2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·8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917756087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4 Endocrine signalling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2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699197279"/>
                  </a:ext>
                </a:extLst>
              </a:tr>
              <a:tr h="47867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5 Endocrine signaling + PI3K, MAPK and RAS signalling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47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9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662598141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r"/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kekihood Chi square ratio test: 43·58 on 10 df, p&lt;0·000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8707417"/>
                  </a:ext>
                </a:extLst>
              </a:tr>
              <a:tr h="97660">
                <a:tc rowSpan="12">
                  <a:txBody>
                    <a:bodyPr/>
                    <a:lstStyle/>
                    <a:p>
                      <a:pPr algn="ctr"/>
                      <a:r>
                        <a:rPr lang="es-ES" sz="8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4</a:t>
                      </a:r>
                      <a:endParaRPr lang="es-GB" sz="8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&gt;7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6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781744135"/>
                  </a:ext>
                </a:extLst>
              </a:tr>
              <a:tr h="10824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1-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5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993492612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dal status N4+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·0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150735609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size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1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0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3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2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187541676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179666728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t tumour grade 3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6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·4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8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267127209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insic subtype: HER2-E vs Luminals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7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0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1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2866136218"/>
                  </a:ext>
                </a:extLst>
              </a:tr>
              <a:tr h="19291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2 EMC + highest ERBB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·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8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·4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001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568812265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3 DNA-damage repair deficiency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·39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6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·2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2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3301725658"/>
                  </a:ext>
                </a:extLst>
              </a:tr>
              <a:tr h="28816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4 Endocrine signalling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·52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4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723731958"/>
                  </a:ext>
                </a:extLst>
              </a:tr>
              <a:tr h="47867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s-E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ster 5 Endocrine signaling + PI3K, MAPK and RAS signalling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·71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5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·16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GB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·35</a:t>
                      </a:r>
                      <a:endParaRPr lang="es-GB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>
                  <a:txBody>
                    <a:bodyPr/>
                    <a:lstStyle/>
                    <a:p>
                      <a:endParaRPr lang="es-GB" sz="8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extLst>
                  <a:ext uri="{0D108BD9-81ED-4DB2-BD59-A6C34878D82A}">
                    <a16:rowId xmlns:a16="http://schemas.microsoft.com/office/drawing/2014/main" val="1391818237"/>
                  </a:ext>
                </a:extLst>
              </a:tr>
              <a:tr h="9766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r>
                        <a:rPr lang="en-US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kekihood</a:t>
                      </a: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hi square ratio test: 45·39 on 11 df, p&lt;0·0001</a:t>
                      </a:r>
                      <a:endParaRPr lang="es-GB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464" marR="3464" marT="346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92566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3869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40</TotalTime>
  <Words>4838</Words>
  <Application>Microsoft Macintosh PowerPoint</Application>
  <PresentationFormat>A4 (210 x 297 mm)</PresentationFormat>
  <Paragraphs>1695</Paragraphs>
  <Slides>13</Slides>
  <Notes>1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resentación de PowerPoint</vt:lpstr>
      <vt:lpstr>Presentación de PowerPoint</vt:lpstr>
      <vt:lpstr>Presentación de PowerPoint</vt:lpstr>
      <vt:lpstr>  Supplementary table S3. Association analysis of signature expression and response to AI in treated patients (n=227) for the three response categories using ordinal logistic regression models with OR towards poor response and for the two Ki672wks  categories: high vs low, using univariate logistic regression models with OR towards high· In bold FDR values are the significant signatures. Abbreviations: ESR1, Estrogen Receptor 1; ERBB2, gene HER2; FOXA1, Forkhead BoxA1;  HRD, Homologous Recombination Deficiency; PGR: Progesterone Receptor; PD-L1, Programmed death-ligand 1; Treg, Regulatory T cells; PTEN, Phosphatase and tensin homolog; IDO1, Indoleamine 2,3-dioxygenase; AR, Androgen Receptor, IFN Gamma, Interferon Gamma; TIS, Tumour Inflammation Signature; PD-L2, Programmed death-ligand 2; TIGIT, T cell immunoreceptor with Ig and ITIM  domain; APM, Antigen Processing Machinery; BRCAness, Breast Cancer Gene deficiency; CDK6, Cyclin-dependant kinase 6; TGFB, Transforming growth Factor Beta; Rb1, Retinoblastoma; SOX2, SRY(Sex determining region Y)-box2; MHC2, major histocompatibility complex 2; PD1, Programmed cell death protein 1; CDK4, Cyclin-dependant kinase 4; CD8 T cells, Cytotoxic T lymphocytes; HER2-E, HER2-Enriched Subtype; LumB, Luminal B subtype; LumA, Luminal A subtype; OR, Odds Ratio; FDR, False discovery rate, CI, Confidence Interval, Ki672w, Ki67 at 2 weeks timepoint.     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Institute of Cancer Resear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Ferreira Leal</dc:creator>
  <cp:lastModifiedBy>edgar jano</cp:lastModifiedBy>
  <cp:revision>475</cp:revision>
  <dcterms:created xsi:type="dcterms:W3CDTF">2021-02-23T20:31:39Z</dcterms:created>
  <dcterms:modified xsi:type="dcterms:W3CDTF">2022-06-21T06:34:26Z</dcterms:modified>
</cp:coreProperties>
</file>